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3" r:id="rId2"/>
    <p:sldId id="260" r:id="rId3"/>
    <p:sldId id="287" r:id="rId4"/>
    <p:sldId id="276" r:id="rId5"/>
    <p:sldId id="288" r:id="rId6"/>
    <p:sldId id="286" r:id="rId7"/>
    <p:sldId id="285" r:id="rId8"/>
    <p:sldId id="282" r:id="rId9"/>
    <p:sldId id="289" r:id="rId10"/>
    <p:sldId id="256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DF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94" autoAdjust="0"/>
    <p:restoredTop sz="95947" autoAdjust="0"/>
  </p:normalViewPr>
  <p:slideViewPr>
    <p:cSldViewPr snapToGrid="0">
      <p:cViewPr varScale="1">
        <p:scale>
          <a:sx n="114" d="100"/>
          <a:sy n="114" d="100"/>
        </p:scale>
        <p:origin x="955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OVID_paper\COVID_paper_calcs_v1.0_check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OVID_paper\COVID_paper_calcs_v1.0_checke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OVID_paper\COVID_paper_calcs_v1.0_checke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OVID_paper\COVID_paper_calcs_v1.0_checked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24759405074366"/>
          <c:y val="0.17171296296296296"/>
          <c:w val="0.85859230096237982"/>
          <c:h val="0.72088764946048411"/>
        </c:manualLayout>
      </c:layout>
      <c:lineChart>
        <c:grouping val="standard"/>
        <c:varyColors val="0"/>
        <c:ser>
          <c:idx val="0"/>
          <c:order val="0"/>
          <c:tx>
            <c:strRef>
              <c:f>Lengths!$S$200</c:f>
              <c:strCache>
                <c:ptCount val="1"/>
                <c:pt idx="0">
                  <c:v>Mock</c:v>
                </c:pt>
              </c:strCache>
            </c:strRef>
          </c:tx>
          <c:spPr>
            <a:ln w="63500" cap="rnd">
              <a:solidFill>
                <a:schemeClr val="accent1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201:$R$234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S$201:$S$234</c:f>
              <c:numCache>
                <c:formatCode>0.00%</c:formatCode>
                <c:ptCount val="34"/>
                <c:pt idx="0">
                  <c:v>5.6272183308728838E-2</c:v>
                </c:pt>
                <c:pt idx="1">
                  <c:v>3.9208311084587118E-2</c:v>
                </c:pt>
                <c:pt idx="2">
                  <c:v>4.3255488896566885E-2</c:v>
                </c:pt>
                <c:pt idx="3">
                  <c:v>2.4937180010679398E-2</c:v>
                </c:pt>
                <c:pt idx="4">
                  <c:v>2.2989760341740741E-2</c:v>
                </c:pt>
                <c:pt idx="5">
                  <c:v>6.7371297546879413E-2</c:v>
                </c:pt>
                <c:pt idx="6">
                  <c:v>0.17216485535697459</c:v>
                </c:pt>
                <c:pt idx="7">
                  <c:v>0.14966194993246851</c:v>
                </c:pt>
                <c:pt idx="8">
                  <c:v>0.11492799258724126</c:v>
                </c:pt>
                <c:pt idx="9">
                  <c:v>9.6806781417847154E-2</c:v>
                </c:pt>
                <c:pt idx="10">
                  <c:v>3.8479599208468135E-2</c:v>
                </c:pt>
                <c:pt idx="11">
                  <c:v>3.7643308100637624E-2</c:v>
                </c:pt>
                <c:pt idx="12">
                  <c:v>2.454298457769262E-2</c:v>
                </c:pt>
                <c:pt idx="13">
                  <c:v>2.8157097088293497E-2</c:v>
                </c:pt>
                <c:pt idx="14">
                  <c:v>3.6305242328108805E-2</c:v>
                </c:pt>
                <c:pt idx="15">
                  <c:v>1.9925322737695133E-2</c:v>
                </c:pt>
                <c:pt idx="16">
                  <c:v>2.4193548387096775E-3</c:v>
                </c:pt>
                <c:pt idx="17">
                  <c:v>5.7287904011056323E-3</c:v>
                </c:pt>
                <c:pt idx="18">
                  <c:v>2.4193548387096775E-3</c:v>
                </c:pt>
                <c:pt idx="19">
                  <c:v>2.4193548387096775E-3</c:v>
                </c:pt>
                <c:pt idx="20">
                  <c:v>4.032258064516129E-4</c:v>
                </c:pt>
                <c:pt idx="21">
                  <c:v>1.2933065301378899E-3</c:v>
                </c:pt>
                <c:pt idx="22">
                  <c:v>3.6290322580645163E-3</c:v>
                </c:pt>
                <c:pt idx="23">
                  <c:v>2.0161290322580645E-3</c:v>
                </c:pt>
                <c:pt idx="24">
                  <c:v>3.3930646731790059E-3</c:v>
                </c:pt>
                <c:pt idx="25">
                  <c:v>4.032258064516129E-4</c:v>
                </c:pt>
                <c:pt idx="26">
                  <c:v>0</c:v>
                </c:pt>
                <c:pt idx="27">
                  <c:v>1.6129032258064516E-3</c:v>
                </c:pt>
                <c:pt idx="28">
                  <c:v>1.2096774193548388E-3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4.032258064516129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F6C-44EC-8834-15A78063E8DF}"/>
            </c:ext>
          </c:extLst>
        </c:ser>
        <c:ser>
          <c:idx val="1"/>
          <c:order val="1"/>
          <c:tx>
            <c:strRef>
              <c:f>Lengths!$T$200</c:f>
              <c:strCache>
                <c:ptCount val="1"/>
                <c:pt idx="0">
                  <c:v>SARS-CoV-2</c:v>
                </c:pt>
              </c:strCache>
            </c:strRef>
          </c:tx>
          <c:spPr>
            <a:ln w="6350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201:$R$234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T$201:$T$234</c:f>
              <c:numCache>
                <c:formatCode>0.00%</c:formatCode>
                <c:ptCount val="34"/>
                <c:pt idx="0">
                  <c:v>1.1946027915909683E-2</c:v>
                </c:pt>
                <c:pt idx="1">
                  <c:v>1.3914026854007066E-2</c:v>
                </c:pt>
                <c:pt idx="2">
                  <c:v>8.656122878679836E-3</c:v>
                </c:pt>
                <c:pt idx="3">
                  <c:v>8.7121749906270227E-3</c:v>
                </c:pt>
                <c:pt idx="4">
                  <c:v>7.9653490010825855E-3</c:v>
                </c:pt>
                <c:pt idx="5">
                  <c:v>2.7966288808996289E-2</c:v>
                </c:pt>
                <c:pt idx="6">
                  <c:v>6.5051877196022845E-2</c:v>
                </c:pt>
                <c:pt idx="7">
                  <c:v>5.7811013665168526E-2</c:v>
                </c:pt>
                <c:pt idx="8">
                  <c:v>6.7692300663829696E-2</c:v>
                </c:pt>
                <c:pt idx="9">
                  <c:v>7.4600842694429292E-2</c:v>
                </c:pt>
                <c:pt idx="10">
                  <c:v>0.11048820109318938</c:v>
                </c:pt>
                <c:pt idx="11">
                  <c:v>0.19991546749118078</c:v>
                </c:pt>
                <c:pt idx="12">
                  <c:v>7.4272913992916495E-2</c:v>
                </c:pt>
                <c:pt idx="13">
                  <c:v>0.11085483662704546</c:v>
                </c:pt>
                <c:pt idx="14">
                  <c:v>9.0319908204061217E-2</c:v>
                </c:pt>
                <c:pt idx="15">
                  <c:v>1.5404290102637868E-2</c:v>
                </c:pt>
                <c:pt idx="16">
                  <c:v>1.621095856190111E-2</c:v>
                </c:pt>
                <c:pt idx="17">
                  <c:v>9.4927125728024794E-3</c:v>
                </c:pt>
                <c:pt idx="18">
                  <c:v>7.0130655389507215E-3</c:v>
                </c:pt>
                <c:pt idx="19">
                  <c:v>3.2825251353433842E-3</c:v>
                </c:pt>
                <c:pt idx="20">
                  <c:v>4.2348085974752503E-3</c:v>
                </c:pt>
                <c:pt idx="21">
                  <c:v>3.3758783840364386E-3</c:v>
                </c:pt>
                <c:pt idx="22">
                  <c:v>4.5110779857827944E-3</c:v>
                </c:pt>
                <c:pt idx="23">
                  <c:v>1.7701221810531914E-3</c:v>
                </c:pt>
                <c:pt idx="24">
                  <c:v>3.5476242639928463E-3</c:v>
                </c:pt>
                <c:pt idx="25">
                  <c:v>2.27797991903595E-4</c:v>
                </c:pt>
                <c:pt idx="26">
                  <c:v>6.7222371605270238E-5</c:v>
                </c:pt>
                <c:pt idx="27">
                  <c:v>9.3353248693054525E-5</c:v>
                </c:pt>
                <c:pt idx="28">
                  <c:v>0</c:v>
                </c:pt>
                <c:pt idx="29">
                  <c:v>1.8670649738610905E-4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4.1450448928970402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F6C-44EC-8834-15A78063E8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212408"/>
        <c:axId val="98210840"/>
      </c:lineChart>
      <c:catAx>
        <c:axId val="98212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0840"/>
        <c:crosses val="autoZero"/>
        <c:auto val="1"/>
        <c:lblAlgn val="ctr"/>
        <c:lblOffset val="100"/>
        <c:noMultiLvlLbl val="0"/>
      </c:catAx>
      <c:valAx>
        <c:axId val="98210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2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40480681298581"/>
          <c:y val="0.10841731751076754"/>
          <c:w val="0.26447645176040235"/>
          <c:h val="0.13863112445629894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24759405074366"/>
          <c:y val="0.17171296296296296"/>
          <c:w val="0.85859230096237982"/>
          <c:h val="0.72088764946048411"/>
        </c:manualLayout>
      </c:layout>
      <c:lineChart>
        <c:grouping val="standard"/>
        <c:varyColors val="0"/>
        <c:ser>
          <c:idx val="0"/>
          <c:order val="0"/>
          <c:tx>
            <c:strRef>
              <c:f>Lengths!$S$240</c:f>
              <c:strCache>
                <c:ptCount val="1"/>
                <c:pt idx="0">
                  <c:v>Mock</c:v>
                </c:pt>
              </c:strCache>
            </c:strRef>
          </c:tx>
          <c:spPr>
            <a:ln w="63500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241:$R$274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S$241:$S$274</c:f>
              <c:numCache>
                <c:formatCode>0.00%</c:formatCode>
                <c:ptCount val="34"/>
                <c:pt idx="0">
                  <c:v>0.14033555131610786</c:v>
                </c:pt>
                <c:pt idx="1">
                  <c:v>5.7315409338716782E-2</c:v>
                </c:pt>
                <c:pt idx="2">
                  <c:v>5.5493533662808979E-2</c:v>
                </c:pt>
                <c:pt idx="3">
                  <c:v>4.0369255963476042E-2</c:v>
                </c:pt>
                <c:pt idx="4">
                  <c:v>5.2070155027487811E-2</c:v>
                </c:pt>
                <c:pt idx="5">
                  <c:v>6.6569232865002201E-2</c:v>
                </c:pt>
                <c:pt idx="6">
                  <c:v>6.5212807958998933E-2</c:v>
                </c:pt>
                <c:pt idx="7">
                  <c:v>5.1518753897721252E-2</c:v>
                </c:pt>
                <c:pt idx="8">
                  <c:v>5.1421397588088294E-2</c:v>
                </c:pt>
                <c:pt idx="9">
                  <c:v>7.7166956830461292E-2</c:v>
                </c:pt>
                <c:pt idx="10">
                  <c:v>6.2231557916323496E-2</c:v>
                </c:pt>
                <c:pt idx="11">
                  <c:v>4.8287877165597064E-2</c:v>
                </c:pt>
                <c:pt idx="12">
                  <c:v>5.6778968557374271E-2</c:v>
                </c:pt>
                <c:pt idx="13">
                  <c:v>3.7076525969063807E-2</c:v>
                </c:pt>
                <c:pt idx="14">
                  <c:v>1.9591675770883783E-2</c:v>
                </c:pt>
                <c:pt idx="15">
                  <c:v>1.3624486686569253E-2</c:v>
                </c:pt>
                <c:pt idx="16">
                  <c:v>1.8956950237643936E-2</c:v>
                </c:pt>
                <c:pt idx="17">
                  <c:v>2.2462077117759625E-2</c:v>
                </c:pt>
                <c:pt idx="18">
                  <c:v>3.1405333051320823E-2</c:v>
                </c:pt>
                <c:pt idx="19">
                  <c:v>2.3059779005300297E-2</c:v>
                </c:pt>
                <c:pt idx="20">
                  <c:v>6.1225006608388857E-3</c:v>
                </c:pt>
                <c:pt idx="21">
                  <c:v>1.188242341678187E-3</c:v>
                </c:pt>
                <c:pt idx="22">
                  <c:v>8.2784883480276506E-4</c:v>
                </c:pt>
                <c:pt idx="23">
                  <c:v>2.4835465044082951E-4</c:v>
                </c:pt>
                <c:pt idx="24">
                  <c:v>1.5950053256764187E-4</c:v>
                </c:pt>
                <c:pt idx="25">
                  <c:v>4.1392441740138249E-5</c:v>
                </c:pt>
                <c:pt idx="26">
                  <c:v>8.2784883480276498E-5</c:v>
                </c:pt>
                <c:pt idx="27">
                  <c:v>9.7411869957434507E-5</c:v>
                </c:pt>
                <c:pt idx="28">
                  <c:v>2.0696220870069125E-5</c:v>
                </c:pt>
                <c:pt idx="29">
                  <c:v>4.1392441740138249E-5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2.2158919517784926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E20-4EEA-8748-4AF68E55CC6C}"/>
            </c:ext>
          </c:extLst>
        </c:ser>
        <c:ser>
          <c:idx val="1"/>
          <c:order val="1"/>
          <c:tx>
            <c:strRef>
              <c:f>Lengths!$T$240</c:f>
              <c:strCache>
                <c:ptCount val="1"/>
                <c:pt idx="0">
                  <c:v>SARS-CoV-2</c:v>
                </c:pt>
              </c:strCache>
            </c:strRef>
          </c:tx>
          <c:spPr>
            <a:ln w="6350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241:$R$274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T$241:$T$274</c:f>
              <c:numCache>
                <c:formatCode>0.00%</c:formatCode>
                <c:ptCount val="34"/>
                <c:pt idx="0">
                  <c:v>8.9373094787900016E-3</c:v>
                </c:pt>
                <c:pt idx="1">
                  <c:v>4.8482452706451601E-3</c:v>
                </c:pt>
                <c:pt idx="2">
                  <c:v>4.2561225574632771E-3</c:v>
                </c:pt>
                <c:pt idx="3">
                  <c:v>3.5329173032405017E-3</c:v>
                </c:pt>
                <c:pt idx="4">
                  <c:v>7.2481290385220951E-3</c:v>
                </c:pt>
                <c:pt idx="5">
                  <c:v>1.546752062152777E-2</c:v>
                </c:pt>
                <c:pt idx="6">
                  <c:v>2.6582369555008672E-2</c:v>
                </c:pt>
                <c:pt idx="7">
                  <c:v>1.8132802772952556E-2</c:v>
                </c:pt>
                <c:pt idx="8">
                  <c:v>2.2510192300311711E-2</c:v>
                </c:pt>
                <c:pt idx="9">
                  <c:v>4.9340100292587216E-2</c:v>
                </c:pt>
                <c:pt idx="10">
                  <c:v>0.11024139740111917</c:v>
                </c:pt>
                <c:pt idx="11">
                  <c:v>0.13912696027096355</c:v>
                </c:pt>
                <c:pt idx="12">
                  <c:v>0.13503002891463251</c:v>
                </c:pt>
                <c:pt idx="13">
                  <c:v>6.5558177188282343E-2</c:v>
                </c:pt>
                <c:pt idx="14">
                  <c:v>2.6244600387851334E-2</c:v>
                </c:pt>
                <c:pt idx="15">
                  <c:v>3.5911741106524009E-2</c:v>
                </c:pt>
                <c:pt idx="16">
                  <c:v>5.2978563097206589E-2</c:v>
                </c:pt>
                <c:pt idx="17">
                  <c:v>6.0118469022077264E-2</c:v>
                </c:pt>
                <c:pt idx="18">
                  <c:v>0.12713646097702322</c:v>
                </c:pt>
                <c:pt idx="19">
                  <c:v>7.2745702590250594E-2</c:v>
                </c:pt>
                <c:pt idx="20">
                  <c:v>1.2464483062508455E-2</c:v>
                </c:pt>
                <c:pt idx="21">
                  <c:v>5.4544276171781972E-4</c:v>
                </c:pt>
                <c:pt idx="22">
                  <c:v>5.4419600894714667E-4</c:v>
                </c:pt>
                <c:pt idx="23">
                  <c:v>2.5365502878824608E-4</c:v>
                </c:pt>
                <c:pt idx="24">
                  <c:v>1.7482172690585026E-4</c:v>
                </c:pt>
                <c:pt idx="25">
                  <c:v>2.3284184688235926E-5</c:v>
                </c:pt>
                <c:pt idx="26">
                  <c:v>1.3982450170580379E-5</c:v>
                </c:pt>
                <c:pt idx="27">
                  <c:v>1.3138883647065962E-5</c:v>
                </c:pt>
                <c:pt idx="28">
                  <c:v>1.3661463470612826E-6</c:v>
                </c:pt>
                <c:pt idx="29">
                  <c:v>8.7791546941086819E-6</c:v>
                </c:pt>
                <c:pt idx="30">
                  <c:v>1.3661463470612826E-6</c:v>
                </c:pt>
                <c:pt idx="31">
                  <c:v>0</c:v>
                </c:pt>
                <c:pt idx="32">
                  <c:v>0</c:v>
                </c:pt>
                <c:pt idx="33">
                  <c:v>7.6742982588208306E-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E20-4EEA-8748-4AF68E55CC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212408"/>
        <c:axId val="98210840"/>
      </c:lineChart>
      <c:catAx>
        <c:axId val="98212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0840"/>
        <c:crosses val="autoZero"/>
        <c:auto val="1"/>
        <c:lblAlgn val="ctr"/>
        <c:lblOffset val="100"/>
        <c:noMultiLvlLbl val="0"/>
      </c:catAx>
      <c:valAx>
        <c:axId val="98210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2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671805440230498"/>
          <c:y val="0.13048171023710997"/>
          <c:w val="0.23543646406866411"/>
          <c:h val="0.1425574151614501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24759405074366"/>
          <c:y val="0.17171296296296296"/>
          <c:w val="0.85859230096237982"/>
          <c:h val="0.72088764946048411"/>
        </c:manualLayout>
      </c:layout>
      <c:lineChart>
        <c:grouping val="standard"/>
        <c:varyColors val="0"/>
        <c:ser>
          <c:idx val="0"/>
          <c:order val="0"/>
          <c:tx>
            <c:strRef>
              <c:f>Lengths!$S$41</c:f>
              <c:strCache>
                <c:ptCount val="1"/>
                <c:pt idx="0">
                  <c:v>Mock</c:v>
                </c:pt>
              </c:strCache>
            </c:strRef>
          </c:tx>
          <c:spPr>
            <a:ln w="63500" cap="rnd">
              <a:solidFill>
                <a:schemeClr val="accent1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42:$R$75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S$42:$S$75</c:f>
              <c:numCache>
                <c:formatCode>0.00%</c:formatCode>
                <c:ptCount val="34"/>
                <c:pt idx="0">
                  <c:v>0.28274914653265215</c:v>
                </c:pt>
                <c:pt idx="1">
                  <c:v>0.17512878218602365</c:v>
                </c:pt>
                <c:pt idx="2">
                  <c:v>0.1494296356646351</c:v>
                </c:pt>
                <c:pt idx="3">
                  <c:v>6.8511020157330155E-2</c:v>
                </c:pt>
                <c:pt idx="4">
                  <c:v>4.3192833641023727E-2</c:v>
                </c:pt>
                <c:pt idx="5">
                  <c:v>2.9533106632205014E-2</c:v>
                </c:pt>
                <c:pt idx="6">
                  <c:v>3.1422818575058756E-2</c:v>
                </c:pt>
                <c:pt idx="7">
                  <c:v>2.1688368623267916E-2</c:v>
                </c:pt>
                <c:pt idx="8">
                  <c:v>1.7048616843166001E-2</c:v>
                </c:pt>
                <c:pt idx="9">
                  <c:v>1.4215805024004848E-2</c:v>
                </c:pt>
                <c:pt idx="10">
                  <c:v>8.4883750291752415E-3</c:v>
                </c:pt>
                <c:pt idx="11">
                  <c:v>6.5816960331848938E-3</c:v>
                </c:pt>
                <c:pt idx="12">
                  <c:v>7.3925767944491589E-3</c:v>
                </c:pt>
                <c:pt idx="13">
                  <c:v>8.0061605250337353E-3</c:v>
                </c:pt>
                <c:pt idx="14">
                  <c:v>1.4505386645145439E-2</c:v>
                </c:pt>
                <c:pt idx="15">
                  <c:v>2.5586858829960618E-2</c:v>
                </c:pt>
                <c:pt idx="16">
                  <c:v>1.9429206010109088E-2</c:v>
                </c:pt>
                <c:pt idx="17">
                  <c:v>3.3145041025965855E-2</c:v>
                </c:pt>
                <c:pt idx="18">
                  <c:v>2.8647445913755069E-2</c:v>
                </c:pt>
                <c:pt idx="19">
                  <c:v>6.8455864435109049E-3</c:v>
                </c:pt>
                <c:pt idx="20">
                  <c:v>4.6658064974864086E-3</c:v>
                </c:pt>
                <c:pt idx="21">
                  <c:v>1.5025108883529197E-3</c:v>
                </c:pt>
                <c:pt idx="22">
                  <c:v>1.3541746087732383E-3</c:v>
                </c:pt>
                <c:pt idx="23">
                  <c:v>1.7299840841464257E-4</c:v>
                </c:pt>
                <c:pt idx="24">
                  <c:v>1.2846117388374658E-4</c:v>
                </c:pt>
                <c:pt idx="25">
                  <c:v>6.9199363365857029E-5</c:v>
                </c:pt>
                <c:pt idx="26">
                  <c:v>3.4599681682928514E-5</c:v>
                </c:pt>
                <c:pt idx="27">
                  <c:v>0</c:v>
                </c:pt>
                <c:pt idx="28">
                  <c:v>6.9199363365857029E-5</c:v>
                </c:pt>
                <c:pt idx="29">
                  <c:v>0</c:v>
                </c:pt>
                <c:pt idx="30">
                  <c:v>3.4599681682928514E-5</c:v>
                </c:pt>
                <c:pt idx="31">
                  <c:v>0</c:v>
                </c:pt>
                <c:pt idx="32">
                  <c:v>0</c:v>
                </c:pt>
                <c:pt idx="33">
                  <c:v>4.1998320333416826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B58-4122-8FA4-58419E30BDDF}"/>
            </c:ext>
          </c:extLst>
        </c:ser>
        <c:ser>
          <c:idx val="1"/>
          <c:order val="1"/>
          <c:tx>
            <c:strRef>
              <c:f>Lengths!$T$41</c:f>
              <c:strCache>
                <c:ptCount val="1"/>
                <c:pt idx="0">
                  <c:v>SARS-CoV-2</c:v>
                </c:pt>
              </c:strCache>
            </c:strRef>
          </c:tx>
          <c:spPr>
            <a:ln w="6350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42:$R$75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T$42:$T$75</c:f>
              <c:numCache>
                <c:formatCode>0.00%</c:formatCode>
                <c:ptCount val="34"/>
                <c:pt idx="0">
                  <c:v>0.14597153421330733</c:v>
                </c:pt>
                <c:pt idx="1">
                  <c:v>9.6220168147437654E-2</c:v>
                </c:pt>
                <c:pt idx="2">
                  <c:v>8.6899269395117718E-2</c:v>
                </c:pt>
                <c:pt idx="3">
                  <c:v>5.3005052307192185E-2</c:v>
                </c:pt>
                <c:pt idx="4">
                  <c:v>3.8098841409288403E-2</c:v>
                </c:pt>
                <c:pt idx="5">
                  <c:v>2.714262361711418E-2</c:v>
                </c:pt>
                <c:pt idx="6">
                  <c:v>3.2703849403883448E-2</c:v>
                </c:pt>
                <c:pt idx="7">
                  <c:v>2.4699685760211115E-2</c:v>
                </c:pt>
                <c:pt idx="8">
                  <c:v>1.9548602131161347E-2</c:v>
                </c:pt>
                <c:pt idx="9">
                  <c:v>2.0178697378272586E-2</c:v>
                </c:pt>
                <c:pt idx="10">
                  <c:v>1.5596412028835717E-2</c:v>
                </c:pt>
                <c:pt idx="11">
                  <c:v>1.6310275622775608E-2</c:v>
                </c:pt>
                <c:pt idx="12">
                  <c:v>1.0065393402172836E-2</c:v>
                </c:pt>
                <c:pt idx="13">
                  <c:v>1.124099843820664E-2</c:v>
                </c:pt>
                <c:pt idx="14">
                  <c:v>2.0086518648176455E-2</c:v>
                </c:pt>
                <c:pt idx="15">
                  <c:v>3.2492533985789107E-2</c:v>
                </c:pt>
                <c:pt idx="16">
                  <c:v>3.2630052320898453E-2</c:v>
                </c:pt>
                <c:pt idx="17">
                  <c:v>0.10027337797591204</c:v>
                </c:pt>
                <c:pt idx="18">
                  <c:v>0.10359698378821362</c:v>
                </c:pt>
                <c:pt idx="19">
                  <c:v>5.8405721430226668E-2</c:v>
                </c:pt>
                <c:pt idx="20">
                  <c:v>4.1616328631164441E-2</c:v>
                </c:pt>
                <c:pt idx="21">
                  <c:v>1.0312400665645455E-2</c:v>
                </c:pt>
                <c:pt idx="22">
                  <c:v>2.2719090605749521E-3</c:v>
                </c:pt>
                <c:pt idx="23">
                  <c:v>2.771104011819117E-4</c:v>
                </c:pt>
                <c:pt idx="24">
                  <c:v>9.3362007555494172E-5</c:v>
                </c:pt>
                <c:pt idx="25">
                  <c:v>7.042043972874889E-5</c:v>
                </c:pt>
                <c:pt idx="26">
                  <c:v>3.1652581268002407E-5</c:v>
                </c:pt>
                <c:pt idx="27">
                  <c:v>5.7353919566863197E-6</c:v>
                </c:pt>
                <c:pt idx="28">
                  <c:v>7.9131453170006019E-6</c:v>
                </c:pt>
                <c:pt idx="29">
                  <c:v>5.7353919566863197E-6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.4084087945749778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B58-4122-8FA4-58419E30BD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212408"/>
        <c:axId val="98210840"/>
      </c:lineChart>
      <c:catAx>
        <c:axId val="98212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0840"/>
        <c:crosses val="autoZero"/>
        <c:auto val="1"/>
        <c:lblAlgn val="ctr"/>
        <c:lblOffset val="100"/>
        <c:noMultiLvlLbl val="0"/>
      </c:catAx>
      <c:valAx>
        <c:axId val="98210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2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219507315957931"/>
          <c:y val="0.10841731751076754"/>
          <c:w val="0.24632944673068133"/>
          <c:h val="0.13863112445629894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24759405074366"/>
          <c:y val="0.17171296296296296"/>
          <c:w val="0.85859230096237982"/>
          <c:h val="0.72088764946048411"/>
        </c:manualLayout>
      </c:layout>
      <c:lineChart>
        <c:grouping val="standard"/>
        <c:varyColors val="0"/>
        <c:ser>
          <c:idx val="0"/>
          <c:order val="0"/>
          <c:tx>
            <c:strRef>
              <c:f>Lengths!$S$278</c:f>
              <c:strCache>
                <c:ptCount val="1"/>
                <c:pt idx="0">
                  <c:v>Mock</c:v>
                </c:pt>
              </c:strCache>
            </c:strRef>
          </c:tx>
          <c:spPr>
            <a:ln w="63500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279:$R$312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S$279:$S$312</c:f>
              <c:numCache>
                <c:formatCode>0.00%</c:formatCode>
                <c:ptCount val="34"/>
                <c:pt idx="0">
                  <c:v>0.12706686724709831</c:v>
                </c:pt>
                <c:pt idx="1">
                  <c:v>6.6090085591953687E-2</c:v>
                </c:pt>
                <c:pt idx="2">
                  <c:v>4.6866389317554477E-2</c:v>
                </c:pt>
                <c:pt idx="3">
                  <c:v>4.5780912274114363E-2</c:v>
                </c:pt>
                <c:pt idx="4">
                  <c:v>5.0293466219218014E-2</c:v>
                </c:pt>
                <c:pt idx="5">
                  <c:v>8.8873167404007455E-2</c:v>
                </c:pt>
                <c:pt idx="6">
                  <c:v>9.2190189415794654E-2</c:v>
                </c:pt>
                <c:pt idx="7">
                  <c:v>8.6790621381237415E-2</c:v>
                </c:pt>
                <c:pt idx="8">
                  <c:v>6.4294208280497547E-2</c:v>
                </c:pt>
                <c:pt idx="9">
                  <c:v>6.7572690850149747E-2</c:v>
                </c:pt>
                <c:pt idx="10">
                  <c:v>7.2867767431359337E-2</c:v>
                </c:pt>
                <c:pt idx="11">
                  <c:v>6.4244946578870921E-2</c:v>
                </c:pt>
                <c:pt idx="12">
                  <c:v>4.5235998954478544E-2</c:v>
                </c:pt>
                <c:pt idx="13">
                  <c:v>1.8292781613064808E-2</c:v>
                </c:pt>
                <c:pt idx="14">
                  <c:v>2.0893435306741589E-2</c:v>
                </c:pt>
                <c:pt idx="15">
                  <c:v>1.4568111433812907E-2</c:v>
                </c:pt>
                <c:pt idx="16">
                  <c:v>9.9288122892469098E-3</c:v>
                </c:pt>
                <c:pt idx="17">
                  <c:v>6.369426751592357E-3</c:v>
                </c:pt>
                <c:pt idx="18">
                  <c:v>7.0140773151785921E-3</c:v>
                </c:pt>
                <c:pt idx="19">
                  <c:v>2.1433392110197314E-3</c:v>
                </c:pt>
                <c:pt idx="20">
                  <c:v>2.0606968902210565E-3</c:v>
                </c:pt>
                <c:pt idx="21">
                  <c:v>1.8733608092918696E-4</c:v>
                </c:pt>
                <c:pt idx="22">
                  <c:v>3.7467216185837392E-4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78E-44C4-9406-ACB3C124C76C}"/>
            </c:ext>
          </c:extLst>
        </c:ser>
        <c:ser>
          <c:idx val="1"/>
          <c:order val="1"/>
          <c:tx>
            <c:strRef>
              <c:f>Lengths!$T$278</c:f>
              <c:strCache>
                <c:ptCount val="1"/>
                <c:pt idx="0">
                  <c:v>SARS-CoV-2</c:v>
                </c:pt>
              </c:strCache>
            </c:strRef>
          </c:tx>
          <c:spPr>
            <a:ln w="6350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Lengths!$R$279:$R$312</c:f>
              <c:numCache>
                <c:formatCode>General</c:formatCode>
                <c:ptCount val="34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</c:numCache>
            </c:numRef>
          </c:cat>
          <c:val>
            <c:numRef>
              <c:f>Lengths!$T$279:$T$312</c:f>
              <c:numCache>
                <c:formatCode>0.00%</c:formatCode>
                <c:ptCount val="34"/>
                <c:pt idx="0">
                  <c:v>6.8075477288580041E-3</c:v>
                </c:pt>
                <c:pt idx="1">
                  <c:v>4.1097433750649608E-3</c:v>
                </c:pt>
                <c:pt idx="2">
                  <c:v>3.4170823617921718E-3</c:v>
                </c:pt>
                <c:pt idx="3">
                  <c:v>3.6529678730069142E-3</c:v>
                </c:pt>
                <c:pt idx="4">
                  <c:v>5.8127068091734842E-3</c:v>
                </c:pt>
                <c:pt idx="5">
                  <c:v>2.6279130615862289E-2</c:v>
                </c:pt>
                <c:pt idx="6">
                  <c:v>6.1975443710350214E-2</c:v>
                </c:pt>
                <c:pt idx="7">
                  <c:v>3.9558579686441192E-2</c:v>
                </c:pt>
                <c:pt idx="8">
                  <c:v>4.58995641595474E-2</c:v>
                </c:pt>
                <c:pt idx="9">
                  <c:v>7.3747964872090691E-2</c:v>
                </c:pt>
                <c:pt idx="10">
                  <c:v>0.14536794437791084</c:v>
                </c:pt>
                <c:pt idx="11">
                  <c:v>0.28429995638419903</c:v>
                </c:pt>
                <c:pt idx="12">
                  <c:v>0.22194159081074857</c:v>
                </c:pt>
                <c:pt idx="13">
                  <c:v>1.9642643136869392E-2</c:v>
                </c:pt>
                <c:pt idx="14">
                  <c:v>1.7093790833723147E-2</c:v>
                </c:pt>
                <c:pt idx="15">
                  <c:v>1.1334855186290141E-2</c:v>
                </c:pt>
                <c:pt idx="16">
                  <c:v>1.4798058858688118E-2</c:v>
                </c:pt>
                <c:pt idx="17">
                  <c:v>7.9694060836793777E-3</c:v>
                </c:pt>
                <c:pt idx="18">
                  <c:v>4.6054261149159684E-3</c:v>
                </c:pt>
                <c:pt idx="19">
                  <c:v>7.8016184858648355E-4</c:v>
                </c:pt>
                <c:pt idx="20">
                  <c:v>4.7684719268325951E-4</c:v>
                </c:pt>
                <c:pt idx="21">
                  <c:v>2.3137671570671404E-4</c:v>
                </c:pt>
                <c:pt idx="22">
                  <c:v>1.6304581191662658E-4</c:v>
                </c:pt>
                <c:pt idx="23">
                  <c:v>2.2776967930029154E-5</c:v>
                </c:pt>
                <c:pt idx="24">
                  <c:v>1.1388483965014577E-5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78E-44C4-9406-ACB3C124C7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212408"/>
        <c:axId val="98210840"/>
      </c:lineChart>
      <c:catAx>
        <c:axId val="98212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0840"/>
        <c:crosses val="autoZero"/>
        <c:auto val="1"/>
        <c:lblAlgn val="ctr"/>
        <c:lblOffset val="100"/>
        <c:noMultiLvlLbl val="0"/>
      </c:catAx>
      <c:valAx>
        <c:axId val="98210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212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209324155508653"/>
          <c:y val="0.10841731751076754"/>
          <c:w val="0.30643128226798977"/>
          <c:h val="0.13863112445629894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B10B41-068D-47B8-99D2-E4F9B770020C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8109DC-4CC5-4928-B4DD-0D5B1EA22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3882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0A4BB9-4945-48B6-B89F-50C97C54C3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81727E-389F-4C7B-82B5-BAF2F9A1FB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DBA81B-E122-4930-B7B6-29DB0232C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277B67-6744-4B6A-99C6-6B4D8577B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FC5E6B-9F8A-403C-8FF1-BEE5529AD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903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9C5F7-96D1-4E14-B3A4-8A861D3D51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3D4AD-AE18-469B-B826-9A2726E3D1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FFADBF-A556-44C8-B1B0-CBB0EA89C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B55CE4-C82B-4CA8-BCD0-15727C4B3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8C9BB7-4FA5-4999-A34E-002B9F1D7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811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659B27-4E8D-4BA5-8797-E85C9D7E06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FFFE88-B462-4D30-ABE9-22A30C28E8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A99C8A-BED1-4262-B8F3-23AF93DD5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1D5DB2-DBD0-4E94-9718-F3240EBB8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06E1D8-E961-4503-999F-B02E29670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486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3335FD-5681-4440-9D9F-07CCC99CC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3689F8-DF1D-4F49-9874-9B3D771B07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F9A1E0-2D52-4ABD-B8A4-3AB23766B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76341A-FF1C-4D39-8B67-9FE5DB9F9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1C5939-0084-495B-978A-A24EBCC94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634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824722-F15F-4367-A393-320740C1F9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C80C5C-D915-4440-97D0-8181FEB3AC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7DA590-24E3-4E9F-9469-28992B2C6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88A874-0CF8-4271-87B3-667A17A2F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8F3834-01A8-4EBA-9BB3-67EA73321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37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FAE451-CA58-4F47-9D9D-2E4965602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38EF7A-5FAE-44C7-9C85-DB788D2C5A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D3E132-96D0-4E47-9954-D7BC704339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6682B4-88EA-410D-9356-B346AA24F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A25343-9CA6-4996-A3BA-D3127A8A1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A4C22A-AE5F-465B-8FAD-160066247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657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D4D98-7933-4631-A381-233AC7C17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3E35B7-F8FC-4AE2-9E95-02198D5B78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5CD189-689B-42C3-A231-2E349DB790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1CF4FA-9E89-4E8E-BCAF-525EB07618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46CD40-D3A3-496F-A156-2979BEC5CA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36914C-0D04-4A0C-AB29-E6ED94BFC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C4B6E2-308F-4851-9BA8-27D484783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A7D2BE-0A2E-4ABF-A330-E1B275DF7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164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9E0065-BDB1-4E52-89DD-2E0A60BD82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42042C-8424-449F-A44D-F3A924C36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E740F7-3D21-43D1-9B67-68DDA24B5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265191-25E5-4E35-B8D3-224E1471F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380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72A9D5-2D4F-45C8-A2FA-9D75A0C59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30FCE6-759D-45D9-BAC7-20A11602D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004DD7C-9AD8-4531-BD1F-7A96FC075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277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CF2A4D-6749-4108-92F3-7F018058C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E26A0-899E-473B-B173-05B7EA2604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FE09DC-3D7F-4215-9A68-1C73849872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A9E90E-DD49-4C16-AAFE-5695A178B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DDD506-EE92-411D-899F-A15CCAE49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AECAAB-3132-40A4-8579-05BDF2453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320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D0474A-82E2-4358-9EA8-479805371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30FB47-749A-441D-B54D-5DB93649DE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CECE7F-DD50-4FF0-986B-F040EC5CB3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921EBE-FF0B-4456-936D-60B0DD949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CEF3EC-E315-41F1-9586-25C631992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FB7D2F-E57B-4D78-8867-50BEC346F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438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91F7BB-EA93-4CDB-86E0-3F8D326C8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67D4FD-D0A0-4F53-9F3B-6822BA72F2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30BF3C-8351-4569-8468-6374715EAA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912D7-0A86-4025-A355-18C5B02A85B1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A79B5-EB39-47E7-8E61-8DF7EDC02C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8DA38-C7BD-447D-8D2D-27F586226D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0274F-4991-4916-AFF8-FD2A8DBB2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566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073ED465-A35D-5955-1722-133AE4899D6B}"/>
              </a:ext>
            </a:extLst>
          </p:cNvPr>
          <p:cNvSpPr txBox="1"/>
          <p:nvPr/>
        </p:nvSpPr>
        <p:spPr>
          <a:xfrm>
            <a:off x="1603248" y="2004140"/>
            <a:ext cx="8729472" cy="1890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sz="18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Viral and host small RNA transcriptome analysis of SARS-CoV-1 and SARS-CoV-2-infected human cells reveals novel viral short RNAs</a:t>
            </a:r>
          </a:p>
          <a:p>
            <a:pPr algn="ctr">
              <a:lnSpc>
                <a:spcPct val="115000"/>
              </a:lnSpc>
              <a:spcBef>
                <a:spcPts val="1200"/>
              </a:spcBef>
              <a:spcAft>
                <a:spcPts val="1200"/>
              </a:spcAft>
            </a:pPr>
            <a:endParaRPr lang="en-US" dirty="0">
              <a:highlight>
                <a:srgbClr val="FFFFFF"/>
              </a:highlight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ctr">
              <a:lnSpc>
                <a:spcPct val="115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sz="1400" b="1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SUPPLEMENTARY FIGURES</a:t>
            </a:r>
            <a:endParaRPr lang="en-US" sz="1400" b="1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5460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63565BC-A276-E785-5BD4-27C6FC5F0142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9</a:t>
            </a:r>
          </a:p>
        </p:txBody>
      </p:sp>
      <p:graphicFrame>
        <p:nvGraphicFramePr>
          <p:cNvPr id="8" name="Table 58">
            <a:extLst>
              <a:ext uri="{FF2B5EF4-FFF2-40B4-BE49-F238E27FC236}">
                <a16:creationId xmlns:a16="http://schemas.microsoft.com/office/drawing/2014/main" id="{01EC7F60-10CD-1184-1F3A-E0706C9B2F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3611003"/>
              </p:ext>
            </p:extLst>
          </p:nvPr>
        </p:nvGraphicFramePr>
        <p:xfrm>
          <a:off x="2701661" y="3732376"/>
          <a:ext cx="3299541" cy="7442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91185">
                  <a:extLst>
                    <a:ext uri="{9D8B030D-6E8A-4147-A177-3AD203B41FA5}">
                      <a16:colId xmlns:a16="http://schemas.microsoft.com/office/drawing/2014/main" val="1448944700"/>
                    </a:ext>
                  </a:extLst>
                </a:gridCol>
                <a:gridCol w="1308356">
                  <a:extLst>
                    <a:ext uri="{9D8B030D-6E8A-4147-A177-3AD203B41FA5}">
                      <a16:colId xmlns:a16="http://schemas.microsoft.com/office/drawing/2014/main" val="37862334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dirty="0">
                          <a:solidFill>
                            <a:schemeClr val="tx1"/>
                          </a:solidFill>
                        </a:rPr>
                        <a:t>NC_045512.2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th strand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188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Percent of total reads</a:t>
                      </a:r>
                      <a:endParaRPr lang="en-US" sz="800" i="1" dirty="0">
                        <a:solidFill>
                          <a:srgbClr val="333333"/>
                        </a:solidFill>
                        <a:effectLst/>
                        <a:highlight>
                          <a:srgbClr val="FFFFFF"/>
                        </a:highlight>
                        <a:ea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8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Average [</a:t>
                      </a:r>
                      <a:r>
                        <a:rPr lang="en-US" sz="800" i="1" dirty="0" err="1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49993</a:t>
                      </a:r>
                      <a:r>
                        <a:rPr lang="en-US" sz="8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,</a:t>
                      </a:r>
                      <a:r>
                        <a:rPr lang="en-US" sz="800" b="1" i="0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 </a:t>
                      </a:r>
                      <a:r>
                        <a:rPr lang="en-US" sz="8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49994]</a:t>
                      </a:r>
                      <a:endParaRPr lang="en-US" sz="800" b="1" i="0" u="none" dirty="0">
                        <a:solidFill>
                          <a:srgbClr val="333333"/>
                        </a:solidFill>
                        <a:effectLst/>
                        <a:highlight>
                          <a:srgbClr val="FFFFFF"/>
                        </a:highlight>
                        <a:ea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,11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0272844"/>
                  </a:ext>
                </a:extLst>
              </a:tr>
            </a:tbl>
          </a:graphicData>
        </a:graphic>
      </p:graphicFrame>
      <p:graphicFrame>
        <p:nvGraphicFramePr>
          <p:cNvPr id="9" name="Table 58">
            <a:extLst>
              <a:ext uri="{FF2B5EF4-FFF2-40B4-BE49-F238E27FC236}">
                <a16:creationId xmlns:a16="http://schemas.microsoft.com/office/drawing/2014/main" id="{5A1E6FC0-23DD-5B1E-AF45-C32A1370EDBD}"/>
              </a:ext>
            </a:extLst>
          </p:cNvPr>
          <p:cNvGraphicFramePr>
            <a:graphicFrameLocks noGrp="1"/>
          </p:cNvGraphicFramePr>
          <p:nvPr/>
        </p:nvGraphicFramePr>
        <p:xfrm>
          <a:off x="2701661" y="1193677"/>
          <a:ext cx="3300984" cy="95033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00984">
                  <a:extLst>
                    <a:ext uri="{9D8B030D-6E8A-4147-A177-3AD203B41FA5}">
                      <a16:colId xmlns:a16="http://schemas.microsoft.com/office/drawing/2014/main" val="1323865238"/>
                    </a:ext>
                  </a:extLst>
                </a:gridCol>
              </a:tblGrid>
              <a:tr h="43518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RS-CoV-2 infected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lu-3 cells (24 h point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18800"/>
                  </a:ext>
                </a:extLst>
              </a:tr>
              <a:tr h="5151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49993</a:t>
                      </a:r>
                      <a:endParaRPr lang="en-US" sz="1000" b="1" i="0" dirty="0">
                        <a:solidFill>
                          <a:srgbClr val="333333"/>
                        </a:solidFill>
                        <a:effectLst/>
                        <a:highlight>
                          <a:srgbClr val="FFFFFF"/>
                        </a:highlight>
                        <a:ea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0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49994</a:t>
                      </a:r>
                      <a:endParaRPr lang="en-US" sz="1000" b="1" i="0" u="none" dirty="0">
                        <a:solidFill>
                          <a:srgbClr val="333333"/>
                        </a:solidFill>
                        <a:effectLst/>
                        <a:highlight>
                          <a:srgbClr val="FFFFFF"/>
                        </a:highlight>
                        <a:ea typeface="Arial" panose="020B0604020202020204" pitchFamily="34" charset="0"/>
                      </a:endParaRPr>
                    </a:p>
                  </a:txBody>
                  <a:tcPr marL="18000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5856484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CA5FF50B-1C2B-02D0-4192-0E97627BC971}"/>
              </a:ext>
            </a:extLst>
          </p:cNvPr>
          <p:cNvSpPr txBox="1"/>
          <p:nvPr/>
        </p:nvSpPr>
        <p:spPr>
          <a:xfrm>
            <a:off x="3614707" y="823094"/>
            <a:ext cx="1499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PolyA RNA-seq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13A7DA2-42D5-3491-ED07-3F5F08D1519F}"/>
              </a:ext>
            </a:extLst>
          </p:cNvPr>
          <p:cNvSpPr/>
          <p:nvPr/>
        </p:nvSpPr>
        <p:spPr>
          <a:xfrm>
            <a:off x="2701661" y="3204580"/>
            <a:ext cx="3300984" cy="96253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464C5E0-81E1-A1ED-FA8A-2BFA7D915D78}"/>
              </a:ext>
            </a:extLst>
          </p:cNvPr>
          <p:cNvSpPr txBox="1"/>
          <p:nvPr/>
        </p:nvSpPr>
        <p:spPr>
          <a:xfrm>
            <a:off x="2628452" y="2895446"/>
            <a:ext cx="1915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C_045512.2 (SARS-CoV-2)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63A093B-E903-8DBF-78DE-6B84F0263564}"/>
              </a:ext>
            </a:extLst>
          </p:cNvPr>
          <p:cNvSpPr/>
          <p:nvPr/>
        </p:nvSpPr>
        <p:spPr>
          <a:xfrm>
            <a:off x="2703104" y="3386089"/>
            <a:ext cx="3300984" cy="96253"/>
          </a:xfrm>
          <a:prstGeom prst="rect">
            <a:avLst/>
          </a:prstGeom>
          <a:solidFill>
            <a:schemeClr val="accent4">
              <a:lumMod val="60000"/>
              <a:lumOff val="40000"/>
              <a:alpha val="7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E632957-3C3B-CF21-6775-FEA21D263B77}"/>
              </a:ext>
            </a:extLst>
          </p:cNvPr>
          <p:cNvCxnSpPr>
            <a:cxnSpLocks/>
          </p:cNvCxnSpPr>
          <p:nvPr/>
        </p:nvCxnSpPr>
        <p:spPr>
          <a:xfrm>
            <a:off x="4313257" y="2299985"/>
            <a:ext cx="0" cy="500389"/>
          </a:xfrm>
          <a:prstGeom prst="straightConnector1">
            <a:avLst/>
          </a:prstGeom>
          <a:ln w="5715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8659121E-7DE7-1512-78C0-F077225D303A}"/>
              </a:ext>
            </a:extLst>
          </p:cNvPr>
          <p:cNvSpPr txBox="1"/>
          <p:nvPr/>
        </p:nvSpPr>
        <p:spPr>
          <a:xfrm>
            <a:off x="4364207" y="2319193"/>
            <a:ext cx="10246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Reads trimming</a:t>
            </a:r>
          </a:p>
          <a:p>
            <a:pPr algn="ctr"/>
            <a:r>
              <a:rPr lang="en-US" sz="1000" b="1" dirty="0"/>
              <a:t>and alignmen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88D582A-4B03-8DDB-30F7-B47790F77A64}"/>
              </a:ext>
            </a:extLst>
          </p:cNvPr>
          <p:cNvSpPr txBox="1"/>
          <p:nvPr/>
        </p:nvSpPr>
        <p:spPr>
          <a:xfrm>
            <a:off x="3091763" y="2360142"/>
            <a:ext cx="1111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i="1" dirty="0"/>
              <a:t>bowtie</a:t>
            </a:r>
          </a:p>
          <a:p>
            <a:pPr algn="ctr"/>
            <a:r>
              <a:rPr lang="en-US" sz="800" i="1" dirty="0"/>
              <a:t>0 mismatches allowed</a:t>
            </a:r>
          </a:p>
        </p:txBody>
      </p:sp>
      <p:graphicFrame>
        <p:nvGraphicFramePr>
          <p:cNvPr id="27" name="Table 58">
            <a:extLst>
              <a:ext uri="{FF2B5EF4-FFF2-40B4-BE49-F238E27FC236}">
                <a16:creationId xmlns:a16="http://schemas.microsoft.com/office/drawing/2014/main" id="{AF4A2E42-EB95-477D-A99E-FDEFA8A252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1195033"/>
              </p:ext>
            </p:extLst>
          </p:nvPr>
        </p:nvGraphicFramePr>
        <p:xfrm>
          <a:off x="6604310" y="3732376"/>
          <a:ext cx="3299541" cy="7442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84504">
                  <a:extLst>
                    <a:ext uri="{9D8B030D-6E8A-4147-A177-3AD203B41FA5}">
                      <a16:colId xmlns:a16="http://schemas.microsoft.com/office/drawing/2014/main" val="1448944700"/>
                    </a:ext>
                  </a:extLst>
                </a:gridCol>
                <a:gridCol w="1215037">
                  <a:extLst>
                    <a:ext uri="{9D8B030D-6E8A-4147-A177-3AD203B41FA5}">
                      <a16:colId xmlns:a16="http://schemas.microsoft.com/office/drawing/2014/main" val="37862334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dirty="0">
                          <a:solidFill>
                            <a:schemeClr val="tx1"/>
                          </a:solidFill>
                        </a:rPr>
                        <a:t>NC_045512.2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th strand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188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Percent of total reads</a:t>
                      </a:r>
                    </a:p>
                    <a:p>
                      <a:pPr algn="ctr" fontAlgn="b"/>
                      <a:r>
                        <a:rPr lang="en-US" sz="800" i="1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Average </a:t>
                      </a:r>
                      <a:r>
                        <a:rPr lang="en-US" sz="8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[</a:t>
                      </a:r>
                      <a:r>
                        <a:rPr lang="en-US" sz="800" i="1" dirty="0" err="1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0027</a:t>
                      </a:r>
                      <a:r>
                        <a:rPr lang="en-US" sz="8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,</a:t>
                      </a:r>
                      <a:r>
                        <a:rPr lang="en-US" sz="800" b="1" i="0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 </a:t>
                      </a:r>
                      <a:r>
                        <a:rPr lang="en-US" sz="8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0028)</a:t>
                      </a:r>
                      <a:endParaRPr lang="en-US" sz="800" b="1" i="0" u="none" dirty="0">
                        <a:solidFill>
                          <a:srgbClr val="333333"/>
                        </a:solidFill>
                        <a:effectLst/>
                        <a:highlight>
                          <a:srgbClr val="FFFFFF"/>
                        </a:highlight>
                        <a:ea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,51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0272844"/>
                  </a:ext>
                </a:extLst>
              </a:tr>
            </a:tbl>
          </a:graphicData>
        </a:graphic>
      </p:graphicFrame>
      <p:graphicFrame>
        <p:nvGraphicFramePr>
          <p:cNvPr id="31" name="Table 58">
            <a:extLst>
              <a:ext uri="{FF2B5EF4-FFF2-40B4-BE49-F238E27FC236}">
                <a16:creationId xmlns:a16="http://schemas.microsoft.com/office/drawing/2014/main" id="{51099112-4EAC-46AB-A0F5-8DE67770DA1E}"/>
              </a:ext>
            </a:extLst>
          </p:cNvPr>
          <p:cNvGraphicFramePr>
            <a:graphicFrameLocks noGrp="1"/>
          </p:cNvGraphicFramePr>
          <p:nvPr/>
        </p:nvGraphicFramePr>
        <p:xfrm>
          <a:off x="6604310" y="1193677"/>
          <a:ext cx="3300984" cy="95033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00984">
                  <a:extLst>
                    <a:ext uri="{9D8B030D-6E8A-4147-A177-3AD203B41FA5}">
                      <a16:colId xmlns:a16="http://schemas.microsoft.com/office/drawing/2014/main" val="1323865238"/>
                    </a:ext>
                  </a:extLst>
                </a:gridCol>
              </a:tblGrid>
              <a:tr h="435183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RS-CoV-2 infected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lu-3 cells (24 h point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18800"/>
                  </a:ext>
                </a:extLst>
              </a:tr>
              <a:tr h="5151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0027</a:t>
                      </a:r>
                      <a:endParaRPr lang="en-US" sz="1000" b="1" i="0" dirty="0">
                        <a:solidFill>
                          <a:srgbClr val="333333"/>
                        </a:solidFill>
                        <a:effectLst/>
                        <a:highlight>
                          <a:srgbClr val="FFFFFF"/>
                        </a:highlight>
                        <a:ea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000" i="1" dirty="0">
                          <a:solidFill>
                            <a:srgbClr val="333333"/>
                          </a:solidFill>
                          <a:effectLst/>
                          <a:highlight>
                            <a:srgbClr val="FFFFFF"/>
                          </a:highlight>
                          <a:ea typeface="Arial" panose="020B0604020202020204" pitchFamily="34" charset="0"/>
                        </a:rPr>
                        <a:t>SRR11550028</a:t>
                      </a:r>
                      <a:endParaRPr lang="en-US" sz="1000" b="1" i="0" u="none" dirty="0">
                        <a:solidFill>
                          <a:srgbClr val="333333"/>
                        </a:solidFill>
                        <a:effectLst/>
                        <a:highlight>
                          <a:srgbClr val="FFFFFF"/>
                        </a:highlight>
                        <a:ea typeface="Arial" panose="020B0604020202020204" pitchFamily="34" charset="0"/>
                      </a:endParaRPr>
                    </a:p>
                  </a:txBody>
                  <a:tcPr marL="18000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5856484"/>
                  </a:ext>
                </a:extLst>
              </a:tr>
            </a:tbl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F712F851-121E-4399-B4A4-0D24233E9F7C}"/>
              </a:ext>
            </a:extLst>
          </p:cNvPr>
          <p:cNvSpPr txBox="1"/>
          <p:nvPr/>
        </p:nvSpPr>
        <p:spPr>
          <a:xfrm>
            <a:off x="7517356" y="823094"/>
            <a:ext cx="1428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Small RNA-seq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8E7CD3D-D7B6-4F15-A513-7913C4171A7B}"/>
              </a:ext>
            </a:extLst>
          </p:cNvPr>
          <p:cNvSpPr/>
          <p:nvPr/>
        </p:nvSpPr>
        <p:spPr>
          <a:xfrm>
            <a:off x="6604310" y="3204580"/>
            <a:ext cx="3300984" cy="96253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651D907-5141-439E-AC97-A1E563B912B2}"/>
              </a:ext>
            </a:extLst>
          </p:cNvPr>
          <p:cNvSpPr txBox="1"/>
          <p:nvPr/>
        </p:nvSpPr>
        <p:spPr>
          <a:xfrm>
            <a:off x="6531101" y="2895446"/>
            <a:ext cx="1915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C_045512.2 (SARS-CoV-2)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975F423B-5186-417E-B609-BF4345FE7751}"/>
              </a:ext>
            </a:extLst>
          </p:cNvPr>
          <p:cNvSpPr/>
          <p:nvPr/>
        </p:nvSpPr>
        <p:spPr>
          <a:xfrm>
            <a:off x="6605753" y="3386089"/>
            <a:ext cx="3300984" cy="96253"/>
          </a:xfrm>
          <a:prstGeom prst="rect">
            <a:avLst/>
          </a:prstGeom>
          <a:solidFill>
            <a:schemeClr val="accent4">
              <a:lumMod val="60000"/>
              <a:lumOff val="40000"/>
              <a:alpha val="7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B1B99D83-042C-435F-8BD5-D4892F191560}"/>
              </a:ext>
            </a:extLst>
          </p:cNvPr>
          <p:cNvCxnSpPr>
            <a:cxnSpLocks/>
          </p:cNvCxnSpPr>
          <p:nvPr/>
        </p:nvCxnSpPr>
        <p:spPr>
          <a:xfrm>
            <a:off x="8215906" y="2299985"/>
            <a:ext cx="0" cy="500389"/>
          </a:xfrm>
          <a:prstGeom prst="straightConnector1">
            <a:avLst/>
          </a:prstGeom>
          <a:ln w="5715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2E2E6C25-5C82-4F6C-9D08-FD9D0108BA75}"/>
              </a:ext>
            </a:extLst>
          </p:cNvPr>
          <p:cNvSpPr txBox="1"/>
          <p:nvPr/>
        </p:nvSpPr>
        <p:spPr>
          <a:xfrm>
            <a:off x="8266856" y="2319193"/>
            <a:ext cx="10246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Reads trimming</a:t>
            </a:r>
          </a:p>
          <a:p>
            <a:pPr algn="ctr"/>
            <a:r>
              <a:rPr lang="en-US" sz="1000" b="1" dirty="0"/>
              <a:t>and alignme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BE10CE6-2A4C-40E5-A957-EFEDC567B4EE}"/>
              </a:ext>
            </a:extLst>
          </p:cNvPr>
          <p:cNvSpPr txBox="1"/>
          <p:nvPr/>
        </p:nvSpPr>
        <p:spPr>
          <a:xfrm>
            <a:off x="6994412" y="2360142"/>
            <a:ext cx="1111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i="1" dirty="0"/>
              <a:t>bowtie</a:t>
            </a:r>
          </a:p>
          <a:p>
            <a:pPr algn="ctr"/>
            <a:r>
              <a:rPr lang="en-US" sz="800" i="1" dirty="0"/>
              <a:t>0 mismatches allowed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C4948B18-DCBF-4367-88B0-BBAA0306FAB3}"/>
              </a:ext>
            </a:extLst>
          </p:cNvPr>
          <p:cNvSpPr/>
          <p:nvPr/>
        </p:nvSpPr>
        <p:spPr>
          <a:xfrm>
            <a:off x="2701661" y="5872477"/>
            <a:ext cx="7202190" cy="181509"/>
          </a:xfrm>
          <a:prstGeom prst="rect">
            <a:avLst/>
          </a:prstGeom>
          <a:solidFill>
            <a:schemeClr val="accent2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9683A03-E2A7-48E2-BCD2-F78397CBCB07}"/>
              </a:ext>
            </a:extLst>
          </p:cNvPr>
          <p:cNvSpPr txBox="1"/>
          <p:nvPr/>
        </p:nvSpPr>
        <p:spPr>
          <a:xfrm>
            <a:off x="2628452" y="6057844"/>
            <a:ext cx="18601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SARS-CoV-2 genomic RN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5428F1-74F6-4BBB-93D2-9E3FD703EDE3}"/>
              </a:ext>
            </a:extLst>
          </p:cNvPr>
          <p:cNvSpPr txBox="1"/>
          <p:nvPr/>
        </p:nvSpPr>
        <p:spPr>
          <a:xfrm>
            <a:off x="2390023" y="517966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de-DE" b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5371A34-93AF-4619-A2A4-2A576E31D237}"/>
              </a:ext>
            </a:extLst>
          </p:cNvPr>
          <p:cNvSpPr txBox="1"/>
          <p:nvPr/>
        </p:nvSpPr>
        <p:spPr>
          <a:xfrm>
            <a:off x="2390023" y="4694534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de-DE" b="1" dirty="0"/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6481224-1197-4D4F-987C-CC8733922F9D}"/>
              </a:ext>
            </a:extLst>
          </p:cNvPr>
          <p:cNvCxnSpPr>
            <a:cxnSpLocks/>
          </p:cNvCxnSpPr>
          <p:nvPr/>
        </p:nvCxnSpPr>
        <p:spPr>
          <a:xfrm>
            <a:off x="3057399" y="5622511"/>
            <a:ext cx="0" cy="229826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3B806DAF-6267-4D3F-88A7-A9EE0F1ACFE7}"/>
              </a:ext>
            </a:extLst>
          </p:cNvPr>
          <p:cNvSpPr txBox="1"/>
          <p:nvPr/>
        </p:nvSpPr>
        <p:spPr>
          <a:xfrm>
            <a:off x="2757212" y="5342066"/>
            <a:ext cx="604653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/>
              <a:t>2451 F</a:t>
            </a:r>
            <a:endParaRPr lang="de-DE" sz="1200" b="1" dirty="0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9CC840D3-1507-4379-BC61-8A4CE487D534}"/>
              </a:ext>
            </a:extLst>
          </p:cNvPr>
          <p:cNvCxnSpPr>
            <a:cxnSpLocks/>
          </p:cNvCxnSpPr>
          <p:nvPr/>
        </p:nvCxnSpPr>
        <p:spPr>
          <a:xfrm>
            <a:off x="9485725" y="5619065"/>
            <a:ext cx="0" cy="229826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F9126F94-79EC-44AA-82AB-D04AF6854C96}"/>
              </a:ext>
            </a:extLst>
          </p:cNvPr>
          <p:cNvSpPr txBox="1"/>
          <p:nvPr/>
        </p:nvSpPr>
        <p:spPr>
          <a:xfrm>
            <a:off x="9145258" y="5318480"/>
            <a:ext cx="68320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/>
              <a:t>29096 F</a:t>
            </a:r>
            <a:endParaRPr lang="de-DE" sz="12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7C98469-A145-4C98-8F89-DC52EF36505D}"/>
              </a:ext>
            </a:extLst>
          </p:cNvPr>
          <p:cNvSpPr txBox="1"/>
          <p:nvPr/>
        </p:nvSpPr>
        <p:spPr>
          <a:xfrm>
            <a:off x="3272821" y="4937004"/>
            <a:ext cx="12714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u="sng" dirty="0"/>
              <a:t>Average CPM of reads containing </a:t>
            </a:r>
            <a:r>
              <a:rPr lang="en-US" sz="800" b="1" u="sng" dirty="0"/>
              <a:t>2451 F</a:t>
            </a:r>
            <a:r>
              <a:rPr lang="en-US" sz="800" u="sng" dirty="0"/>
              <a:t>):</a:t>
            </a:r>
          </a:p>
          <a:p>
            <a:endParaRPr lang="en-US" sz="800" u="sng" dirty="0"/>
          </a:p>
          <a:p>
            <a:r>
              <a:rPr lang="en-US" sz="800" dirty="0"/>
              <a:t>PolyA RNA-seq: </a:t>
            </a:r>
            <a:r>
              <a:rPr lang="en-US" sz="800" b="1" dirty="0"/>
              <a:t>33.9</a:t>
            </a:r>
          </a:p>
          <a:p>
            <a:r>
              <a:rPr lang="en-US" sz="800" dirty="0"/>
              <a:t>Small RNA-seq: </a:t>
            </a:r>
            <a:r>
              <a:rPr lang="en-US" sz="800" b="1" dirty="0"/>
              <a:t>260.0</a:t>
            </a:r>
            <a:endParaRPr lang="de-DE" sz="8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8B0B980-760E-4843-83C0-2C9A2EC72C1A}"/>
              </a:ext>
            </a:extLst>
          </p:cNvPr>
          <p:cNvSpPr txBox="1"/>
          <p:nvPr/>
        </p:nvSpPr>
        <p:spPr>
          <a:xfrm>
            <a:off x="8033269" y="4906334"/>
            <a:ext cx="125822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u="sng" dirty="0"/>
              <a:t>Average CPM of reads containing </a:t>
            </a:r>
            <a:r>
              <a:rPr lang="en-US" sz="800" b="1" u="sng" dirty="0"/>
              <a:t>29096 F</a:t>
            </a:r>
            <a:r>
              <a:rPr lang="en-US" sz="800" u="sng" dirty="0"/>
              <a:t>):</a:t>
            </a:r>
          </a:p>
          <a:p>
            <a:endParaRPr lang="en-US" sz="800" u="sng" dirty="0"/>
          </a:p>
          <a:p>
            <a:r>
              <a:rPr lang="en-US" sz="800" dirty="0"/>
              <a:t>PolyA RNA-seq: </a:t>
            </a:r>
            <a:r>
              <a:rPr lang="en-US" sz="800" b="1" dirty="0"/>
              <a:t>3001.3</a:t>
            </a:r>
          </a:p>
          <a:p>
            <a:r>
              <a:rPr lang="en-US" sz="800" dirty="0"/>
              <a:t>Small RNA-seq: </a:t>
            </a:r>
            <a:r>
              <a:rPr lang="en-US" sz="800" b="1" dirty="0"/>
              <a:t>297.8</a:t>
            </a:r>
            <a:endParaRPr lang="de-DE" sz="800" b="1" dirty="0"/>
          </a:p>
        </p:txBody>
      </p:sp>
    </p:spTree>
    <p:extLst>
      <p:ext uri="{BB962C8B-B14F-4D97-AF65-F5344CB8AC3E}">
        <p14:creationId xmlns:p14="http://schemas.microsoft.com/office/powerpoint/2010/main" val="3167384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8FC23D9C-98FC-4D14-829C-9F958CE6F0E7}"/>
              </a:ext>
            </a:extLst>
          </p:cNvPr>
          <p:cNvSpPr txBox="1"/>
          <p:nvPr/>
        </p:nvSpPr>
        <p:spPr>
          <a:xfrm rot="16200000">
            <a:off x="314667" y="1722105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1</a:t>
            </a:r>
            <a:endParaRPr lang="en-US" sz="12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D0A478F-49D2-45E0-99B1-232F4F78ADBE}"/>
              </a:ext>
            </a:extLst>
          </p:cNvPr>
          <p:cNvSpPr txBox="1"/>
          <p:nvPr/>
        </p:nvSpPr>
        <p:spPr>
          <a:xfrm rot="16200000">
            <a:off x="314664" y="2827499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2</a:t>
            </a:r>
            <a:endParaRPr lang="en-US" sz="12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0B194B4-C8FE-445E-B728-02E0B2068772}"/>
              </a:ext>
            </a:extLst>
          </p:cNvPr>
          <p:cNvSpPr txBox="1"/>
          <p:nvPr/>
        </p:nvSpPr>
        <p:spPr>
          <a:xfrm>
            <a:off x="1062362" y="1054886"/>
            <a:ext cx="28191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ARS-CoV-1 only reads (forward strand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22CB921-1CDD-4548-B953-DE09109F87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322" y="1331885"/>
            <a:ext cx="4800383" cy="20971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8A55C20-4679-4B9E-98AB-9EC727C3B6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3322" y="3749868"/>
            <a:ext cx="4800383" cy="20922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5B799BE-5C79-4E4D-91E2-6AB64C5AB5F7}"/>
              </a:ext>
            </a:extLst>
          </p:cNvPr>
          <p:cNvSpPr txBox="1"/>
          <p:nvPr/>
        </p:nvSpPr>
        <p:spPr>
          <a:xfrm>
            <a:off x="1062362" y="3465247"/>
            <a:ext cx="28191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ARS-CoV-1 only reads (reverse strand)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F6DA0077-B6D5-4E8C-90B1-DB1D4CC039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3974" y="1331886"/>
            <a:ext cx="4799551" cy="20971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9C837A98-698F-43A7-8A51-95A34209A5EC}"/>
              </a:ext>
            </a:extLst>
          </p:cNvPr>
          <p:cNvSpPr txBox="1"/>
          <p:nvPr/>
        </p:nvSpPr>
        <p:spPr>
          <a:xfrm>
            <a:off x="6340961" y="1054886"/>
            <a:ext cx="28191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ARS-CoV-2 only reads (forward strand)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886A643F-8641-4CF3-A182-773971E0C9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13974" y="3749868"/>
            <a:ext cx="4799551" cy="20976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3BC8F835-19FB-432B-A00C-E2AF342CD1EC}"/>
              </a:ext>
            </a:extLst>
          </p:cNvPr>
          <p:cNvSpPr txBox="1"/>
          <p:nvPr/>
        </p:nvSpPr>
        <p:spPr>
          <a:xfrm>
            <a:off x="6340960" y="3416480"/>
            <a:ext cx="28191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ARS-CoV-2 only reads (reverse strand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8C9C7AD-9199-F516-ECE7-1301DBE64871}"/>
              </a:ext>
            </a:extLst>
          </p:cNvPr>
          <p:cNvSpPr txBox="1"/>
          <p:nvPr/>
        </p:nvSpPr>
        <p:spPr>
          <a:xfrm rot="16200000">
            <a:off x="5610537" y="1726583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1</a:t>
            </a:r>
            <a:endParaRPr lang="en-US" sz="12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F0DFCBD-25D3-25BF-3C18-D06B0A302FD5}"/>
              </a:ext>
            </a:extLst>
          </p:cNvPr>
          <p:cNvSpPr txBox="1"/>
          <p:nvPr/>
        </p:nvSpPr>
        <p:spPr>
          <a:xfrm rot="16200000">
            <a:off x="5610534" y="2831977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2</a:t>
            </a:r>
            <a:endParaRPr lang="en-US" sz="12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6280552-ACB1-08F7-2743-E73C6F86D62F}"/>
              </a:ext>
            </a:extLst>
          </p:cNvPr>
          <p:cNvSpPr txBox="1"/>
          <p:nvPr/>
        </p:nvSpPr>
        <p:spPr>
          <a:xfrm rot="16200000">
            <a:off x="314664" y="4083699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1</a:t>
            </a:r>
            <a:endParaRPr lang="en-US" sz="12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12396F-D7D6-360F-5565-4D40DA13B5D2}"/>
              </a:ext>
            </a:extLst>
          </p:cNvPr>
          <p:cNvSpPr txBox="1"/>
          <p:nvPr/>
        </p:nvSpPr>
        <p:spPr>
          <a:xfrm rot="16200000">
            <a:off x="314661" y="5189093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2</a:t>
            </a:r>
            <a:endParaRPr lang="en-US" sz="1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41DDDB-2D16-4B9E-7608-7E0C1B41EBA9}"/>
              </a:ext>
            </a:extLst>
          </p:cNvPr>
          <p:cNvSpPr txBox="1"/>
          <p:nvPr/>
        </p:nvSpPr>
        <p:spPr>
          <a:xfrm rot="16200000">
            <a:off x="5612743" y="4083699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1</a:t>
            </a:r>
            <a:endParaRPr lang="en-US" sz="12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92167FA-16F2-B1BF-B070-302D2EBA45FC}"/>
              </a:ext>
            </a:extLst>
          </p:cNvPr>
          <p:cNvSpPr txBox="1"/>
          <p:nvPr/>
        </p:nvSpPr>
        <p:spPr>
          <a:xfrm rot="16200000">
            <a:off x="5612740" y="5189093"/>
            <a:ext cx="12976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2</a:t>
            </a:r>
            <a:endParaRPr lang="en-US" sz="12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4D26311-9C9C-FD8E-D3E1-C17757AB438B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7105051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527664F6-D40D-E3B8-471E-7A3ECF5C52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3877" y="650172"/>
            <a:ext cx="7604302" cy="27178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0C55032-2E8A-526E-84E3-77C0244417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3877" y="3969082"/>
            <a:ext cx="7604302" cy="271207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ECC81E3-4010-C0BB-E302-12229F335FD9}"/>
              </a:ext>
            </a:extLst>
          </p:cNvPr>
          <p:cNvSpPr txBox="1"/>
          <p:nvPr/>
        </p:nvSpPr>
        <p:spPr>
          <a:xfrm>
            <a:off x="2499550" y="302704"/>
            <a:ext cx="28191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ARS-CoV-2 only reads (forward strand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849B1C-E33A-84F0-4DB5-55CB7AA57143}"/>
              </a:ext>
            </a:extLst>
          </p:cNvPr>
          <p:cNvSpPr txBox="1"/>
          <p:nvPr/>
        </p:nvSpPr>
        <p:spPr>
          <a:xfrm>
            <a:off x="5789230" y="646847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9 (I4)</a:t>
            </a:r>
            <a:endParaRPr lang="en-US" sz="8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4F3145-325D-93D5-AE49-F35CC85FE50B}"/>
              </a:ext>
            </a:extLst>
          </p:cNvPr>
          <p:cNvSpPr txBox="1"/>
          <p:nvPr/>
        </p:nvSpPr>
        <p:spPr>
          <a:xfrm>
            <a:off x="5786309" y="1100237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30 (I4)</a:t>
            </a:r>
            <a:endParaRPr lang="en-US" sz="8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97DB16-F370-7FE1-D14A-9A77B48450F7}"/>
              </a:ext>
            </a:extLst>
          </p:cNvPr>
          <p:cNvSpPr txBox="1"/>
          <p:nvPr/>
        </p:nvSpPr>
        <p:spPr>
          <a:xfrm>
            <a:off x="5786308" y="1534243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5 (I12)</a:t>
            </a:r>
            <a:endParaRPr lang="en-US" sz="8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0C87C3-4045-1F7A-CFC6-719FA5BFD94A}"/>
              </a:ext>
            </a:extLst>
          </p:cNvPr>
          <p:cNvSpPr txBox="1"/>
          <p:nvPr/>
        </p:nvSpPr>
        <p:spPr>
          <a:xfrm>
            <a:off x="5786307" y="1987308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6 (I12)</a:t>
            </a:r>
            <a:endParaRPr lang="en-US" sz="8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E11BDF6-9768-0D02-8F7F-DFD1C9908720}"/>
              </a:ext>
            </a:extLst>
          </p:cNvPr>
          <p:cNvSpPr txBox="1"/>
          <p:nvPr/>
        </p:nvSpPr>
        <p:spPr>
          <a:xfrm>
            <a:off x="5786307" y="2429101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7 (I24)</a:t>
            </a:r>
            <a:endParaRPr lang="en-US" sz="8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A52E50-ED3D-64CD-B9EE-6B59E1D859CA}"/>
              </a:ext>
            </a:extLst>
          </p:cNvPr>
          <p:cNvSpPr txBox="1"/>
          <p:nvPr/>
        </p:nvSpPr>
        <p:spPr>
          <a:xfrm>
            <a:off x="5786307" y="2870894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8 (I24)</a:t>
            </a:r>
            <a:endParaRPr lang="en-US" sz="8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7AECE66-0DFE-EAF3-16CD-B3076482A58E}"/>
              </a:ext>
            </a:extLst>
          </p:cNvPr>
          <p:cNvSpPr txBox="1"/>
          <p:nvPr/>
        </p:nvSpPr>
        <p:spPr>
          <a:xfrm>
            <a:off x="2563877" y="3588011"/>
            <a:ext cx="28191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ARS-CoV-2 only reads (reverse strand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61EFA4E-C568-689F-BE22-FA6CEFCE4B18}"/>
              </a:ext>
            </a:extLst>
          </p:cNvPr>
          <p:cNvSpPr txBox="1"/>
          <p:nvPr/>
        </p:nvSpPr>
        <p:spPr>
          <a:xfrm>
            <a:off x="5875369" y="3942629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9 (I4)</a:t>
            </a:r>
            <a:endParaRPr lang="en-US" sz="8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47CDA39-51FA-8D74-AF17-C2042A845E64}"/>
              </a:ext>
            </a:extLst>
          </p:cNvPr>
          <p:cNvSpPr txBox="1"/>
          <p:nvPr/>
        </p:nvSpPr>
        <p:spPr>
          <a:xfrm>
            <a:off x="5872448" y="4396019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30 (I4)</a:t>
            </a:r>
            <a:endParaRPr lang="en-US" sz="8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7D323A-98D3-A1C0-464C-36E28EACE6E4}"/>
              </a:ext>
            </a:extLst>
          </p:cNvPr>
          <p:cNvSpPr txBox="1"/>
          <p:nvPr/>
        </p:nvSpPr>
        <p:spPr>
          <a:xfrm>
            <a:off x="5872447" y="4830025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5 (I12)</a:t>
            </a:r>
            <a:endParaRPr lang="en-US" sz="8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D8F00C7-A72E-1743-A311-42F0F031B902}"/>
              </a:ext>
            </a:extLst>
          </p:cNvPr>
          <p:cNvSpPr txBox="1"/>
          <p:nvPr/>
        </p:nvSpPr>
        <p:spPr>
          <a:xfrm>
            <a:off x="5872446" y="5283090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6 (I12)</a:t>
            </a:r>
            <a:endParaRPr lang="en-US" sz="8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408F37F-DAEE-A79C-5D84-0E766423ED6E}"/>
              </a:ext>
            </a:extLst>
          </p:cNvPr>
          <p:cNvSpPr txBox="1"/>
          <p:nvPr/>
        </p:nvSpPr>
        <p:spPr>
          <a:xfrm>
            <a:off x="5872446" y="5724883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7 (I24)</a:t>
            </a:r>
            <a:endParaRPr lang="en-US" sz="8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F49E76-26F9-2465-74A5-F6BC85D51621}"/>
              </a:ext>
            </a:extLst>
          </p:cNvPr>
          <p:cNvSpPr txBox="1"/>
          <p:nvPr/>
        </p:nvSpPr>
        <p:spPr>
          <a:xfrm>
            <a:off x="5872446" y="6166676"/>
            <a:ext cx="10865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ea typeface="Arial" panose="020B0604020202020204" pitchFamily="34" charset="0"/>
              </a:rPr>
              <a:t>SRR11550028 (I24)</a:t>
            </a:r>
            <a:endParaRPr lang="en-US" sz="8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FC96E58-9D39-68D9-B084-285681FF35B5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6AEA547-B0CE-7AA1-CBA0-3D9965857847}"/>
              </a:ext>
            </a:extLst>
          </p:cNvPr>
          <p:cNvSpPr/>
          <p:nvPr/>
        </p:nvSpPr>
        <p:spPr>
          <a:xfrm>
            <a:off x="9907939" y="594943"/>
            <a:ext cx="77697" cy="283405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EDA04D2-B553-4122-A83A-71B8F28A71D4}"/>
              </a:ext>
            </a:extLst>
          </p:cNvPr>
          <p:cNvSpPr txBox="1"/>
          <p:nvPr/>
        </p:nvSpPr>
        <p:spPr>
          <a:xfrm>
            <a:off x="9684016" y="3425350"/>
            <a:ext cx="55243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b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i="0" u="none" strike="noStrike" dirty="0"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rPr>
              <a:t>29096 F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9B4944C-3B23-69D8-BCF7-3D1D76BE0895}"/>
              </a:ext>
            </a:extLst>
          </p:cNvPr>
          <p:cNvSpPr/>
          <p:nvPr/>
        </p:nvSpPr>
        <p:spPr>
          <a:xfrm>
            <a:off x="3344095" y="594943"/>
            <a:ext cx="77697" cy="283405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42DD480-A220-5231-E07C-7CF164FD166A}"/>
              </a:ext>
            </a:extLst>
          </p:cNvPr>
          <p:cNvSpPr txBox="1"/>
          <p:nvPr/>
        </p:nvSpPr>
        <p:spPr>
          <a:xfrm>
            <a:off x="2806191" y="3393328"/>
            <a:ext cx="47569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b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i="0" u="none" strike="noStrike" dirty="0"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rPr>
              <a:t>2451 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B55367-F8E8-BDCE-DDC2-992BE849B5A7}"/>
              </a:ext>
            </a:extLst>
          </p:cNvPr>
          <p:cNvSpPr txBox="1"/>
          <p:nvPr/>
        </p:nvSpPr>
        <p:spPr>
          <a:xfrm>
            <a:off x="3297121" y="3391457"/>
            <a:ext cx="47569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b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i="0" u="none" strike="noStrike" dirty="0"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rPr>
              <a:t>3178 F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B85E8DE-63FC-C1C0-5FFB-275130211852}"/>
              </a:ext>
            </a:extLst>
          </p:cNvPr>
          <p:cNvSpPr/>
          <p:nvPr/>
        </p:nvSpPr>
        <p:spPr>
          <a:xfrm>
            <a:off x="3160259" y="592065"/>
            <a:ext cx="77697" cy="283405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17094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EB87C613-5B15-07F9-0964-555E258F2D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6789810"/>
              </p:ext>
            </p:extLst>
          </p:nvPr>
        </p:nvGraphicFramePr>
        <p:xfrm>
          <a:off x="2622976" y="4076783"/>
          <a:ext cx="6946048" cy="1961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8054">
                  <a:extLst>
                    <a:ext uri="{9D8B030D-6E8A-4147-A177-3AD203B41FA5}">
                      <a16:colId xmlns:a16="http://schemas.microsoft.com/office/drawing/2014/main" val="2116877151"/>
                    </a:ext>
                  </a:extLst>
                </a:gridCol>
                <a:gridCol w="1170803">
                  <a:extLst>
                    <a:ext uri="{9D8B030D-6E8A-4147-A177-3AD203B41FA5}">
                      <a16:colId xmlns:a16="http://schemas.microsoft.com/office/drawing/2014/main" val="1839596717"/>
                    </a:ext>
                  </a:extLst>
                </a:gridCol>
                <a:gridCol w="1170803">
                  <a:extLst>
                    <a:ext uri="{9D8B030D-6E8A-4147-A177-3AD203B41FA5}">
                      <a16:colId xmlns:a16="http://schemas.microsoft.com/office/drawing/2014/main" val="609254751"/>
                    </a:ext>
                  </a:extLst>
                </a:gridCol>
                <a:gridCol w="1089266">
                  <a:extLst>
                    <a:ext uri="{9D8B030D-6E8A-4147-A177-3AD203B41FA5}">
                      <a16:colId xmlns:a16="http://schemas.microsoft.com/office/drawing/2014/main" val="1534380095"/>
                    </a:ext>
                  </a:extLst>
                </a:gridCol>
                <a:gridCol w="1089266">
                  <a:extLst>
                    <a:ext uri="{9D8B030D-6E8A-4147-A177-3AD203B41FA5}">
                      <a16:colId xmlns:a16="http://schemas.microsoft.com/office/drawing/2014/main" val="48910192"/>
                    </a:ext>
                  </a:extLst>
                </a:gridCol>
                <a:gridCol w="927856">
                  <a:extLst>
                    <a:ext uri="{9D8B030D-6E8A-4147-A177-3AD203B41FA5}">
                      <a16:colId xmlns:a16="http://schemas.microsoft.com/office/drawing/2014/main" val="808370807"/>
                    </a:ext>
                  </a:extLst>
                </a:gridCol>
              </a:tblGrid>
              <a:tr h="2957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tRNA</a:t>
                      </a:r>
                    </a:p>
                    <a:p>
                      <a:pPr algn="ctr" fontAlgn="b"/>
                      <a:r>
                        <a:rPr lang="en-US" sz="1000" b="1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(top 10 DE transcripts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>
                          <a:latin typeface="+mn-lt"/>
                        </a:rPr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15 (M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>
                          <a:latin typeface="+mn-lt"/>
                        </a:rPr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16 (M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>
                          <a:latin typeface="+mn-lt"/>
                        </a:rPr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27 (I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>
                          <a:latin typeface="+mn-lt"/>
                        </a:rPr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28 (I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>
                          <a:latin typeface="+mn-lt"/>
                        </a:rPr>
                        <a:t>Log-fold-change</a:t>
                      </a:r>
                      <a:endParaRPr lang="en-US" sz="1000" b="1" i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8641959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SeC-TCA-1-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4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7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,0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57415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His-GTG-1-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4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90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His-GTG-1-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4811998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His-GTG-1-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9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3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540895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His-GTG-1-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3800075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Lys-TTT-5-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145529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Gln-CTG-5-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1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6398692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His-GTG-1-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8612988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His-GTG-1-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045520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NA-His-GTG-1-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9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,9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913027"/>
                  </a:ext>
                </a:extLst>
              </a:tr>
            </a:tbl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3D55A59-5FBE-5E5F-B7E5-ECE3B9D64A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1588418"/>
              </p:ext>
            </p:extLst>
          </p:nvPr>
        </p:nvGraphicFramePr>
        <p:xfrm>
          <a:off x="2622976" y="948996"/>
          <a:ext cx="6946048" cy="98343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02319">
                  <a:extLst>
                    <a:ext uri="{9D8B030D-6E8A-4147-A177-3AD203B41FA5}">
                      <a16:colId xmlns:a16="http://schemas.microsoft.com/office/drawing/2014/main" val="2116877151"/>
                    </a:ext>
                  </a:extLst>
                </a:gridCol>
                <a:gridCol w="1170432">
                  <a:extLst>
                    <a:ext uri="{9D8B030D-6E8A-4147-A177-3AD203B41FA5}">
                      <a16:colId xmlns:a16="http://schemas.microsoft.com/office/drawing/2014/main" val="1839596717"/>
                    </a:ext>
                  </a:extLst>
                </a:gridCol>
                <a:gridCol w="1164336">
                  <a:extLst>
                    <a:ext uri="{9D8B030D-6E8A-4147-A177-3AD203B41FA5}">
                      <a16:colId xmlns:a16="http://schemas.microsoft.com/office/drawing/2014/main" val="609254751"/>
                    </a:ext>
                  </a:extLst>
                </a:gridCol>
                <a:gridCol w="1078992">
                  <a:extLst>
                    <a:ext uri="{9D8B030D-6E8A-4147-A177-3AD203B41FA5}">
                      <a16:colId xmlns:a16="http://schemas.microsoft.com/office/drawing/2014/main" val="326006150"/>
                    </a:ext>
                  </a:extLst>
                </a:gridCol>
                <a:gridCol w="1091755">
                  <a:extLst>
                    <a:ext uri="{9D8B030D-6E8A-4147-A177-3AD203B41FA5}">
                      <a16:colId xmlns:a16="http://schemas.microsoft.com/office/drawing/2014/main" val="456245047"/>
                    </a:ext>
                  </a:extLst>
                </a:gridCol>
                <a:gridCol w="938214">
                  <a:extLst>
                    <a:ext uri="{9D8B030D-6E8A-4147-A177-3AD203B41FA5}">
                      <a16:colId xmlns:a16="http://schemas.microsoft.com/office/drawing/2014/main" val="2083207645"/>
                    </a:ext>
                  </a:extLst>
                </a:gridCol>
              </a:tblGrid>
              <a:tr h="3277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Y-RNA</a:t>
                      </a:r>
                    </a:p>
                    <a:p>
                      <a:pPr algn="ctr" fontAlgn="b"/>
                      <a:r>
                        <a:rPr lang="en-US" sz="1000" b="1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(major transcripts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15 (M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16 (M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27 (I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28 (I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Log-fold-change</a:t>
                      </a:r>
                      <a:endParaRPr lang="en-US" sz="1000" b="1" i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8641959"/>
                  </a:ext>
                </a:extLst>
              </a:tr>
              <a:tr h="163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RNY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8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685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33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0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574156"/>
                  </a:ext>
                </a:extLst>
              </a:tr>
              <a:tr h="163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RNY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68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3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887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657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906"/>
                  </a:ext>
                </a:extLst>
              </a:tr>
              <a:tr h="163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RNY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4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15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29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4811998"/>
                  </a:ext>
                </a:extLst>
              </a:tr>
              <a:tr h="163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RNY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1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9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87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41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540895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E790DA5-4A1D-94FB-D711-962B990621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696111"/>
              </p:ext>
            </p:extLst>
          </p:nvPr>
        </p:nvGraphicFramePr>
        <p:xfrm>
          <a:off x="2622976" y="2024048"/>
          <a:ext cx="6946048" cy="1961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8054">
                  <a:extLst>
                    <a:ext uri="{9D8B030D-6E8A-4147-A177-3AD203B41FA5}">
                      <a16:colId xmlns:a16="http://schemas.microsoft.com/office/drawing/2014/main" val="2116877151"/>
                    </a:ext>
                  </a:extLst>
                </a:gridCol>
                <a:gridCol w="1170803">
                  <a:extLst>
                    <a:ext uri="{9D8B030D-6E8A-4147-A177-3AD203B41FA5}">
                      <a16:colId xmlns:a16="http://schemas.microsoft.com/office/drawing/2014/main" val="1839596717"/>
                    </a:ext>
                  </a:extLst>
                </a:gridCol>
                <a:gridCol w="1170803">
                  <a:extLst>
                    <a:ext uri="{9D8B030D-6E8A-4147-A177-3AD203B41FA5}">
                      <a16:colId xmlns:a16="http://schemas.microsoft.com/office/drawing/2014/main" val="609254751"/>
                    </a:ext>
                  </a:extLst>
                </a:gridCol>
                <a:gridCol w="1089266">
                  <a:extLst>
                    <a:ext uri="{9D8B030D-6E8A-4147-A177-3AD203B41FA5}">
                      <a16:colId xmlns:a16="http://schemas.microsoft.com/office/drawing/2014/main" val="1534380095"/>
                    </a:ext>
                  </a:extLst>
                </a:gridCol>
                <a:gridCol w="1089266">
                  <a:extLst>
                    <a:ext uri="{9D8B030D-6E8A-4147-A177-3AD203B41FA5}">
                      <a16:colId xmlns:a16="http://schemas.microsoft.com/office/drawing/2014/main" val="48910192"/>
                    </a:ext>
                  </a:extLst>
                </a:gridCol>
                <a:gridCol w="927856">
                  <a:extLst>
                    <a:ext uri="{9D8B030D-6E8A-4147-A177-3AD203B41FA5}">
                      <a16:colId xmlns:a16="http://schemas.microsoft.com/office/drawing/2014/main" val="808370807"/>
                    </a:ext>
                  </a:extLst>
                </a:gridCol>
              </a:tblGrid>
              <a:tr h="2957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Misc. Y-RNA</a:t>
                      </a:r>
                    </a:p>
                    <a:p>
                      <a:pPr algn="ctr" fontAlgn="b"/>
                      <a:r>
                        <a:rPr lang="en-US" sz="1000" b="1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(top 10 DE transcripts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15 (M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16 (M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27 (I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Raw reads 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SRR11550028 (I24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dirty="0"/>
                        <a:t>Log-fold-change</a:t>
                      </a:r>
                      <a:endParaRPr lang="en-US" sz="1000" b="1" i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8641959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ENST00000362540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7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57415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384240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06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6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90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384001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5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5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4811998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384750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4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3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4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4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540895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362354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3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3800075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365274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145529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365085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9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6398692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459189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8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8612988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384478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0455206"/>
                  </a:ext>
                </a:extLst>
              </a:tr>
              <a:tr h="1648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NST00000459091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6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7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91302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4BA8370-0FB0-B28B-24DC-E52FC0F5B16F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8167583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9DCFDDDD-C460-4375-98F4-2F2819895D63}"/>
              </a:ext>
            </a:extLst>
          </p:cNvPr>
          <p:cNvGraphicFramePr>
            <a:graphicFrameLocks/>
          </p:cNvGraphicFramePr>
          <p:nvPr/>
        </p:nvGraphicFramePr>
        <p:xfrm>
          <a:off x="4572239" y="1260287"/>
          <a:ext cx="3499200" cy="244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9A9A4964-605B-F92C-CDA7-787882E185D4}"/>
              </a:ext>
            </a:extLst>
          </p:cNvPr>
          <p:cNvGraphicFramePr>
            <a:graphicFrameLocks noGrp="1"/>
          </p:cNvGraphicFramePr>
          <p:nvPr/>
        </p:nvGraphicFramePr>
        <p:xfrm>
          <a:off x="512064" y="4132780"/>
          <a:ext cx="3498565" cy="1722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46450">
                  <a:extLst>
                    <a:ext uri="{9D8B030D-6E8A-4147-A177-3AD203B41FA5}">
                      <a16:colId xmlns:a16="http://schemas.microsoft.com/office/drawing/2014/main" val="2116877151"/>
                    </a:ext>
                  </a:extLst>
                </a:gridCol>
                <a:gridCol w="1152115">
                  <a:extLst>
                    <a:ext uri="{9D8B030D-6E8A-4147-A177-3AD203B41FA5}">
                      <a16:colId xmlns:a16="http://schemas.microsoft.com/office/drawing/2014/main" val="402905134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Top 5 overrepresented </a:t>
                      </a:r>
                    </a:p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RNY-mapped reads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+mn-lt"/>
                        </a:rPr>
                        <a:t>(SARS-CoV-2 infected Calu-3 cells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% in: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7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8641959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CCCCCACAACCGCGCTTGACTAGCTTGCTGTT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5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2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57415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CTCCCACTGCTTCACTTGACTAGC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7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2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90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CTCCCACTGCTTCACTTGACTAG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3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7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4811998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TCTCACTACTGCACTTGACTAGTC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4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4%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540895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CCCCACAACCGCGCTTGACTAGCTTGCTGTTT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4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2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4263235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6C1A037-8345-92B6-D8A8-EBA1CF06306C}"/>
              </a:ext>
            </a:extLst>
          </p:cNvPr>
          <p:cNvGraphicFramePr>
            <a:graphicFrameLocks noGrp="1"/>
          </p:cNvGraphicFramePr>
          <p:nvPr/>
        </p:nvGraphicFramePr>
        <p:xfrm>
          <a:off x="4474463" y="4129886"/>
          <a:ext cx="3596975" cy="1722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12452">
                  <a:extLst>
                    <a:ext uri="{9D8B030D-6E8A-4147-A177-3AD203B41FA5}">
                      <a16:colId xmlns:a16="http://schemas.microsoft.com/office/drawing/2014/main" val="2116877151"/>
                    </a:ext>
                  </a:extLst>
                </a:gridCol>
                <a:gridCol w="1184523">
                  <a:extLst>
                    <a:ext uri="{9D8B030D-6E8A-4147-A177-3AD203B41FA5}">
                      <a16:colId xmlns:a16="http://schemas.microsoft.com/office/drawing/2014/main" val="402905134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Top 5 overrepresented </a:t>
                      </a:r>
                    </a:p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vault RNA-mapped reads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+mn-lt"/>
                        </a:rPr>
                        <a:t>(SARS-CoV-2 infected Calu-3 cells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% in: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7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8641959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CCCGCGGGCGCTCTCCAGTCCTT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.92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63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57415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GAGACCCGCGGGCGCTCTCCAGTCCTT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49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39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90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GACCCGCGGGCGCTCTCCAGTCCTT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40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74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4811998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CCCGCGGGCGCTCTCCAGTCCT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50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15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540895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CCCGCGGGTGCTTTCCAGCTCTT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12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1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4263235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4AD2127A-CD4D-A1CF-AC27-C5AE85F2DA6C}"/>
              </a:ext>
            </a:extLst>
          </p:cNvPr>
          <p:cNvGraphicFramePr>
            <a:graphicFrameLocks noGrp="1"/>
          </p:cNvGraphicFramePr>
          <p:nvPr/>
        </p:nvGraphicFramePr>
        <p:xfrm>
          <a:off x="8516651" y="4129886"/>
          <a:ext cx="3446081" cy="1722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11250">
                  <a:extLst>
                    <a:ext uri="{9D8B030D-6E8A-4147-A177-3AD203B41FA5}">
                      <a16:colId xmlns:a16="http://schemas.microsoft.com/office/drawing/2014/main" val="2116877151"/>
                    </a:ext>
                  </a:extLst>
                </a:gridCol>
                <a:gridCol w="1134831">
                  <a:extLst>
                    <a:ext uri="{9D8B030D-6E8A-4147-A177-3AD203B41FA5}">
                      <a16:colId xmlns:a16="http://schemas.microsoft.com/office/drawing/2014/main" val="402905134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Top 5 overrepresented </a:t>
                      </a:r>
                    </a:p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tRNA-mapped reads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+mn-lt"/>
                        </a:rPr>
                        <a:t>(SARS-CoV-2 infected Calu-3 cells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% in: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7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8641959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TTTCCGTAGTGTAGTGGTTATCACGTTCGCC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84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28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57415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TTTCCGTAGTGTAGTGGTTATCACGTTCGC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83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22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90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CCCTGGTGGTCTAGTGGTTAGGATTCGGCG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63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8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4811998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CCCGGATAGCTCAGTCGGTAGAGCATCAGAC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76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4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540895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GAGAGGTCCCGGGTT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56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13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4263235"/>
                  </a:ext>
                </a:extLst>
              </a:tr>
            </a:tbl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6C1AF5F5-79DA-4D4B-B012-5DFE8C1BEF40}"/>
              </a:ext>
            </a:extLst>
          </p:cNvPr>
          <p:cNvGraphicFramePr>
            <a:graphicFrameLocks/>
          </p:cNvGraphicFramePr>
          <p:nvPr/>
        </p:nvGraphicFramePr>
        <p:xfrm>
          <a:off x="512064" y="1259996"/>
          <a:ext cx="3498565" cy="24431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339CC2F0-B8C4-BD6E-F67D-1CF811417790}"/>
              </a:ext>
            </a:extLst>
          </p:cNvPr>
          <p:cNvSpPr txBox="1"/>
          <p:nvPr/>
        </p:nvSpPr>
        <p:spPr>
          <a:xfrm>
            <a:off x="1825168" y="3622727"/>
            <a:ext cx="8210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Read lengt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271A188-44E9-2C14-C2D3-42429E831567}"/>
              </a:ext>
            </a:extLst>
          </p:cNvPr>
          <p:cNvSpPr txBox="1"/>
          <p:nvPr/>
        </p:nvSpPr>
        <p:spPr>
          <a:xfrm>
            <a:off x="5766550" y="3622725"/>
            <a:ext cx="8210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Read lengt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3FDCC7-A617-40D7-C542-AFA61207A0CB}"/>
              </a:ext>
            </a:extLst>
          </p:cNvPr>
          <p:cNvSpPr txBox="1"/>
          <p:nvPr/>
        </p:nvSpPr>
        <p:spPr>
          <a:xfrm>
            <a:off x="9844774" y="3622726"/>
            <a:ext cx="8210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Read lengt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F36985-1E8E-80A8-DF61-D811C06CC0DA}"/>
              </a:ext>
            </a:extLst>
          </p:cNvPr>
          <p:cNvSpPr txBox="1"/>
          <p:nvPr/>
        </p:nvSpPr>
        <p:spPr>
          <a:xfrm rot="16200000">
            <a:off x="-261223" y="2391896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%  of total RNY read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DE8C9A-7C24-972A-168E-E61851570138}"/>
              </a:ext>
            </a:extLst>
          </p:cNvPr>
          <p:cNvSpPr txBox="1"/>
          <p:nvPr/>
        </p:nvSpPr>
        <p:spPr>
          <a:xfrm rot="16200000">
            <a:off x="3646015" y="2350749"/>
            <a:ext cx="1608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%  of total vault RNA read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AFAE2FB-1FD9-21E6-69BF-D6221128F382}"/>
              </a:ext>
            </a:extLst>
          </p:cNvPr>
          <p:cNvSpPr txBox="1"/>
          <p:nvPr/>
        </p:nvSpPr>
        <p:spPr>
          <a:xfrm rot="16200000">
            <a:off x="7662472" y="2389610"/>
            <a:ext cx="1354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%  of total tRNA read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F08F7E9-CDE4-9365-0776-90E1B93F5FA8}"/>
              </a:ext>
            </a:extLst>
          </p:cNvPr>
          <p:cNvSpPr txBox="1"/>
          <p:nvPr/>
        </p:nvSpPr>
        <p:spPr>
          <a:xfrm>
            <a:off x="91746" y="897233"/>
            <a:ext cx="285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C41DA7A6-02E7-4F7F-9D3A-9ED916A5179D}"/>
              </a:ext>
            </a:extLst>
          </p:cNvPr>
          <p:cNvGraphicFramePr>
            <a:graphicFrameLocks/>
          </p:cNvGraphicFramePr>
          <p:nvPr/>
        </p:nvGraphicFramePr>
        <p:xfrm>
          <a:off x="8463532" y="1256480"/>
          <a:ext cx="3499200" cy="244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A4BC53D1-3099-F33D-7935-9D4F8708A835}"/>
              </a:ext>
            </a:extLst>
          </p:cNvPr>
          <p:cNvSpPr txBox="1"/>
          <p:nvPr/>
        </p:nvSpPr>
        <p:spPr>
          <a:xfrm>
            <a:off x="4132064" y="918259"/>
            <a:ext cx="285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F9FB70D-CF9B-9200-3320-3A5072D37748}"/>
              </a:ext>
            </a:extLst>
          </p:cNvPr>
          <p:cNvSpPr txBox="1"/>
          <p:nvPr/>
        </p:nvSpPr>
        <p:spPr>
          <a:xfrm>
            <a:off x="8247977" y="928893"/>
            <a:ext cx="285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A15B6C2-609C-8470-27C9-5870D664806E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39180969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15B6C2-609C-8470-27C9-5870D664806E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FFA953F-6325-3D4B-D349-3E9984EF5E15}"/>
              </a:ext>
            </a:extLst>
          </p:cNvPr>
          <p:cNvSpPr txBox="1"/>
          <p:nvPr/>
        </p:nvSpPr>
        <p:spPr>
          <a:xfrm>
            <a:off x="2496170" y="805169"/>
            <a:ext cx="2000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_004393 (RNY4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980A04-1654-8099-AD7E-7B9334586D1F}"/>
              </a:ext>
            </a:extLst>
          </p:cNvPr>
          <p:cNvSpPr txBox="1"/>
          <p:nvPr/>
        </p:nvSpPr>
        <p:spPr>
          <a:xfrm>
            <a:off x="7545855" y="805169"/>
            <a:ext cx="2000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_004392 (RNY3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FEB75E7-3D8F-9E62-7883-82A741A19A59}"/>
              </a:ext>
            </a:extLst>
          </p:cNvPr>
          <p:cNvSpPr txBox="1"/>
          <p:nvPr/>
        </p:nvSpPr>
        <p:spPr>
          <a:xfrm>
            <a:off x="2413775" y="3563586"/>
            <a:ext cx="2000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_004391 (RNY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E29D03-B87C-9977-9BDB-E185880C1951}"/>
              </a:ext>
            </a:extLst>
          </p:cNvPr>
          <p:cNvSpPr txBox="1"/>
          <p:nvPr/>
        </p:nvSpPr>
        <p:spPr>
          <a:xfrm>
            <a:off x="7646994" y="3556978"/>
            <a:ext cx="2000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_001571 (RNY5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82A621-9248-4F57-22C8-BB1DDB49CA7F}"/>
              </a:ext>
            </a:extLst>
          </p:cNvPr>
          <p:cNvSpPr txBox="1"/>
          <p:nvPr/>
        </p:nvSpPr>
        <p:spPr>
          <a:xfrm>
            <a:off x="754575" y="1458960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34CDFF-C71E-6F27-485A-18ED194A76FC}"/>
              </a:ext>
            </a:extLst>
          </p:cNvPr>
          <p:cNvSpPr txBox="1"/>
          <p:nvPr/>
        </p:nvSpPr>
        <p:spPr>
          <a:xfrm>
            <a:off x="705328" y="192217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A052BD-C560-642D-D7B2-90E8479DC7DE}"/>
              </a:ext>
            </a:extLst>
          </p:cNvPr>
          <p:cNvSpPr txBox="1"/>
          <p:nvPr/>
        </p:nvSpPr>
        <p:spPr>
          <a:xfrm>
            <a:off x="859216" y="2399750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7387F3F-809B-D017-80E1-7296E2BE2234}"/>
              </a:ext>
            </a:extLst>
          </p:cNvPr>
          <p:cNvSpPr txBox="1"/>
          <p:nvPr/>
        </p:nvSpPr>
        <p:spPr>
          <a:xfrm>
            <a:off x="814401" y="2863020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D08333-3F01-F417-A842-F543D5E9CCBA}"/>
              </a:ext>
            </a:extLst>
          </p:cNvPr>
          <p:cNvSpPr txBox="1"/>
          <p:nvPr/>
        </p:nvSpPr>
        <p:spPr>
          <a:xfrm>
            <a:off x="754575" y="4232114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2A7A2B-0968-EA33-E798-3558B1C7425D}"/>
              </a:ext>
            </a:extLst>
          </p:cNvPr>
          <p:cNvSpPr txBox="1"/>
          <p:nvPr/>
        </p:nvSpPr>
        <p:spPr>
          <a:xfrm>
            <a:off x="705328" y="469532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70DCCE-5191-F66E-0D36-601F4967362B}"/>
              </a:ext>
            </a:extLst>
          </p:cNvPr>
          <p:cNvSpPr txBox="1"/>
          <p:nvPr/>
        </p:nvSpPr>
        <p:spPr>
          <a:xfrm>
            <a:off x="859216" y="5172904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07DEAE-34E2-7AA5-78AC-43B7A8616CFD}"/>
              </a:ext>
            </a:extLst>
          </p:cNvPr>
          <p:cNvSpPr txBox="1"/>
          <p:nvPr/>
        </p:nvSpPr>
        <p:spPr>
          <a:xfrm>
            <a:off x="814401" y="5636174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95AABC-6776-4B87-BC23-9F4528B00B3B}"/>
              </a:ext>
            </a:extLst>
          </p:cNvPr>
          <p:cNvSpPr txBox="1"/>
          <p:nvPr/>
        </p:nvSpPr>
        <p:spPr>
          <a:xfrm>
            <a:off x="5832219" y="1458960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A81122-EEDD-E753-2FFF-C671F3CDA7EC}"/>
              </a:ext>
            </a:extLst>
          </p:cNvPr>
          <p:cNvSpPr txBox="1"/>
          <p:nvPr/>
        </p:nvSpPr>
        <p:spPr>
          <a:xfrm>
            <a:off x="5782972" y="192217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A7E09B1-A7ED-6023-0294-92B99E5F80CA}"/>
              </a:ext>
            </a:extLst>
          </p:cNvPr>
          <p:cNvSpPr txBox="1"/>
          <p:nvPr/>
        </p:nvSpPr>
        <p:spPr>
          <a:xfrm>
            <a:off x="5936860" y="2399750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77AD0EA-D882-57CA-8819-1AFEE740E94E}"/>
              </a:ext>
            </a:extLst>
          </p:cNvPr>
          <p:cNvSpPr txBox="1"/>
          <p:nvPr/>
        </p:nvSpPr>
        <p:spPr>
          <a:xfrm>
            <a:off x="5892045" y="2863020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058C287-8CB7-558A-7923-E66E63C4F59D}"/>
              </a:ext>
            </a:extLst>
          </p:cNvPr>
          <p:cNvSpPr txBox="1"/>
          <p:nvPr/>
        </p:nvSpPr>
        <p:spPr>
          <a:xfrm>
            <a:off x="5832150" y="4232114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4CA9A29-2849-4014-5F34-9EFD95FE1679}"/>
              </a:ext>
            </a:extLst>
          </p:cNvPr>
          <p:cNvSpPr txBox="1"/>
          <p:nvPr/>
        </p:nvSpPr>
        <p:spPr>
          <a:xfrm>
            <a:off x="5782903" y="469532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FF33432-24BC-3378-BC65-C0CC66C24809}"/>
              </a:ext>
            </a:extLst>
          </p:cNvPr>
          <p:cNvSpPr txBox="1"/>
          <p:nvPr/>
        </p:nvSpPr>
        <p:spPr>
          <a:xfrm>
            <a:off x="5936791" y="5172904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2845230-7649-9AF9-840C-AEE676F2453D}"/>
              </a:ext>
            </a:extLst>
          </p:cNvPr>
          <p:cNvSpPr txBox="1"/>
          <p:nvPr/>
        </p:nvSpPr>
        <p:spPr>
          <a:xfrm>
            <a:off x="5891976" y="5636174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9CAB43-72EC-FE6D-60BE-C4E1BD257F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0192" y="1174501"/>
            <a:ext cx="4022425" cy="21042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7E3E010-2F73-6CC9-7F73-5A30083FBB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9408" y="1186420"/>
            <a:ext cx="3942403" cy="2054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B48D8566-AB92-A84D-8590-6682A20BAD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3468" y="3931966"/>
            <a:ext cx="4016933" cy="21061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2FA1329C-C90B-C842-7197-29BBDAA4CD2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19409" y="3932919"/>
            <a:ext cx="3935698" cy="205402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215180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15B6C2-609C-8470-27C9-5870D664806E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FFA953F-6325-3D4B-D349-3E9984EF5E15}"/>
              </a:ext>
            </a:extLst>
          </p:cNvPr>
          <p:cNvSpPr txBox="1"/>
          <p:nvPr/>
        </p:nvSpPr>
        <p:spPr>
          <a:xfrm>
            <a:off x="2852530" y="805169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_0358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980A04-1654-8099-AD7E-7B9334586D1F}"/>
              </a:ext>
            </a:extLst>
          </p:cNvPr>
          <p:cNvSpPr txBox="1"/>
          <p:nvPr/>
        </p:nvSpPr>
        <p:spPr>
          <a:xfrm>
            <a:off x="8037281" y="800022"/>
            <a:ext cx="1167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_2670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FEB75E7-3D8F-9E62-7883-82A741A19A59}"/>
              </a:ext>
            </a:extLst>
          </p:cNvPr>
          <p:cNvSpPr txBox="1"/>
          <p:nvPr/>
        </p:nvSpPr>
        <p:spPr>
          <a:xfrm>
            <a:off x="2870987" y="3563586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 2670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E29D03-B87C-9977-9BDB-E185880C1951}"/>
              </a:ext>
            </a:extLst>
          </p:cNvPr>
          <p:cNvSpPr txBox="1"/>
          <p:nvPr/>
        </p:nvSpPr>
        <p:spPr>
          <a:xfrm>
            <a:off x="8157984" y="3597319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R 2670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82A621-9248-4F57-22C8-BB1DDB49CA7F}"/>
              </a:ext>
            </a:extLst>
          </p:cNvPr>
          <p:cNvSpPr txBox="1"/>
          <p:nvPr/>
        </p:nvSpPr>
        <p:spPr>
          <a:xfrm>
            <a:off x="754575" y="1458960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34CDFF-C71E-6F27-485A-18ED194A76FC}"/>
              </a:ext>
            </a:extLst>
          </p:cNvPr>
          <p:cNvSpPr txBox="1"/>
          <p:nvPr/>
        </p:nvSpPr>
        <p:spPr>
          <a:xfrm>
            <a:off x="705328" y="192217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A052BD-C560-642D-D7B2-90E8479DC7DE}"/>
              </a:ext>
            </a:extLst>
          </p:cNvPr>
          <p:cNvSpPr txBox="1"/>
          <p:nvPr/>
        </p:nvSpPr>
        <p:spPr>
          <a:xfrm>
            <a:off x="859216" y="2399750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7387F3F-809B-D017-80E1-7296E2BE2234}"/>
              </a:ext>
            </a:extLst>
          </p:cNvPr>
          <p:cNvSpPr txBox="1"/>
          <p:nvPr/>
        </p:nvSpPr>
        <p:spPr>
          <a:xfrm>
            <a:off x="814401" y="2863020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D08333-3F01-F417-A842-F543D5E9CCBA}"/>
              </a:ext>
            </a:extLst>
          </p:cNvPr>
          <p:cNvSpPr txBox="1"/>
          <p:nvPr/>
        </p:nvSpPr>
        <p:spPr>
          <a:xfrm>
            <a:off x="754575" y="4232114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2A7A2B-0968-EA33-E798-3558B1C7425D}"/>
              </a:ext>
            </a:extLst>
          </p:cNvPr>
          <p:cNvSpPr txBox="1"/>
          <p:nvPr/>
        </p:nvSpPr>
        <p:spPr>
          <a:xfrm>
            <a:off x="705328" y="469532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70DCCE-5191-F66E-0D36-601F4967362B}"/>
              </a:ext>
            </a:extLst>
          </p:cNvPr>
          <p:cNvSpPr txBox="1"/>
          <p:nvPr/>
        </p:nvSpPr>
        <p:spPr>
          <a:xfrm>
            <a:off x="859216" y="5172904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07DEAE-34E2-7AA5-78AC-43B7A8616CFD}"/>
              </a:ext>
            </a:extLst>
          </p:cNvPr>
          <p:cNvSpPr txBox="1"/>
          <p:nvPr/>
        </p:nvSpPr>
        <p:spPr>
          <a:xfrm>
            <a:off x="814401" y="5636174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95AABC-6776-4B87-BC23-9F4528B00B3B}"/>
              </a:ext>
            </a:extLst>
          </p:cNvPr>
          <p:cNvSpPr txBox="1"/>
          <p:nvPr/>
        </p:nvSpPr>
        <p:spPr>
          <a:xfrm>
            <a:off x="5832219" y="1458960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A81122-EEDD-E753-2FFF-C671F3CDA7EC}"/>
              </a:ext>
            </a:extLst>
          </p:cNvPr>
          <p:cNvSpPr txBox="1"/>
          <p:nvPr/>
        </p:nvSpPr>
        <p:spPr>
          <a:xfrm>
            <a:off x="5782972" y="192217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A7E09B1-A7ED-6023-0294-92B99E5F80CA}"/>
              </a:ext>
            </a:extLst>
          </p:cNvPr>
          <p:cNvSpPr txBox="1"/>
          <p:nvPr/>
        </p:nvSpPr>
        <p:spPr>
          <a:xfrm>
            <a:off x="5936860" y="2399750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77AD0EA-D882-57CA-8819-1AFEE740E94E}"/>
              </a:ext>
            </a:extLst>
          </p:cNvPr>
          <p:cNvSpPr txBox="1"/>
          <p:nvPr/>
        </p:nvSpPr>
        <p:spPr>
          <a:xfrm>
            <a:off x="5892045" y="2863020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058C287-8CB7-558A-7923-E66E63C4F59D}"/>
              </a:ext>
            </a:extLst>
          </p:cNvPr>
          <p:cNvSpPr txBox="1"/>
          <p:nvPr/>
        </p:nvSpPr>
        <p:spPr>
          <a:xfrm>
            <a:off x="5832150" y="4232114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4CA9A29-2849-4014-5F34-9EFD95FE1679}"/>
              </a:ext>
            </a:extLst>
          </p:cNvPr>
          <p:cNvSpPr txBox="1"/>
          <p:nvPr/>
        </p:nvSpPr>
        <p:spPr>
          <a:xfrm>
            <a:off x="5782903" y="469532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FF33432-24BC-3378-BC65-C0CC66C24809}"/>
              </a:ext>
            </a:extLst>
          </p:cNvPr>
          <p:cNvSpPr txBox="1"/>
          <p:nvPr/>
        </p:nvSpPr>
        <p:spPr>
          <a:xfrm>
            <a:off x="5936791" y="5172904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2845230-7649-9AF9-840C-AEE676F2453D}"/>
              </a:ext>
            </a:extLst>
          </p:cNvPr>
          <p:cNvSpPr txBox="1"/>
          <p:nvPr/>
        </p:nvSpPr>
        <p:spPr>
          <a:xfrm>
            <a:off x="5891976" y="5636174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EE8840-E521-F015-CF40-942EDB247F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5222" y="1174175"/>
            <a:ext cx="4027393" cy="20995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526497F-28E3-8783-EE39-C10E31C1A8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1575" y="1169354"/>
            <a:ext cx="4002149" cy="21008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CFDF2ACB-5357-DDFE-5017-39E3746058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5222" y="3932918"/>
            <a:ext cx="4027393" cy="21044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38361FA4-9E61-84C8-6CE4-F8FA8E441C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19408" y="3926309"/>
            <a:ext cx="4044316" cy="211683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165200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15B6C2-609C-8470-27C9-5870D664806E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A4C47DA-C9F1-2D4C-94F6-CD40DF86BB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5222" y="1175962"/>
            <a:ext cx="4027395" cy="20970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A4B7711-EC83-A7EF-8C4F-C49AB24770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5114" y="1175962"/>
            <a:ext cx="4027395" cy="20995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FFA953F-6325-3D4B-D349-3E9984EF5E15}"/>
              </a:ext>
            </a:extLst>
          </p:cNvPr>
          <p:cNvSpPr txBox="1"/>
          <p:nvPr/>
        </p:nvSpPr>
        <p:spPr>
          <a:xfrm>
            <a:off x="2617204" y="805169"/>
            <a:ext cx="1918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RNA-SeC-TCA-1-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980A04-1654-8099-AD7E-7B9334586D1F}"/>
              </a:ext>
            </a:extLst>
          </p:cNvPr>
          <p:cNvSpPr txBox="1"/>
          <p:nvPr/>
        </p:nvSpPr>
        <p:spPr>
          <a:xfrm>
            <a:off x="7660160" y="805169"/>
            <a:ext cx="1930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RNA-Pro-TGG-2-1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D810737-8830-EC12-CD2B-AF62BF84B2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5222" y="3932919"/>
            <a:ext cx="4027395" cy="21017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FEB75E7-3D8F-9E62-7883-82A741A19A59}"/>
              </a:ext>
            </a:extLst>
          </p:cNvPr>
          <p:cNvSpPr txBox="1"/>
          <p:nvPr/>
        </p:nvSpPr>
        <p:spPr>
          <a:xfrm>
            <a:off x="2514633" y="3563586"/>
            <a:ext cx="1836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RNA-Lys-TTT-3-1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543EC89-C14C-877F-532D-7FFCCD3977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15114" y="3932918"/>
            <a:ext cx="4002149" cy="20995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FE29D03-B87C-9977-9BDB-E185880C1951}"/>
              </a:ext>
            </a:extLst>
          </p:cNvPr>
          <p:cNvSpPr txBox="1"/>
          <p:nvPr/>
        </p:nvSpPr>
        <p:spPr>
          <a:xfrm>
            <a:off x="7680614" y="3556978"/>
            <a:ext cx="18806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RNA-Gly-CCC-2-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82A621-9248-4F57-22C8-BB1DDB49CA7F}"/>
              </a:ext>
            </a:extLst>
          </p:cNvPr>
          <p:cNvSpPr txBox="1"/>
          <p:nvPr/>
        </p:nvSpPr>
        <p:spPr>
          <a:xfrm>
            <a:off x="754575" y="1458960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34CDFF-C71E-6F27-485A-18ED194A76FC}"/>
              </a:ext>
            </a:extLst>
          </p:cNvPr>
          <p:cNvSpPr txBox="1"/>
          <p:nvPr/>
        </p:nvSpPr>
        <p:spPr>
          <a:xfrm>
            <a:off x="705328" y="192217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A052BD-C560-642D-D7B2-90E8479DC7DE}"/>
              </a:ext>
            </a:extLst>
          </p:cNvPr>
          <p:cNvSpPr txBox="1"/>
          <p:nvPr/>
        </p:nvSpPr>
        <p:spPr>
          <a:xfrm>
            <a:off x="859216" y="2399750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7387F3F-809B-D017-80E1-7296E2BE2234}"/>
              </a:ext>
            </a:extLst>
          </p:cNvPr>
          <p:cNvSpPr txBox="1"/>
          <p:nvPr/>
        </p:nvSpPr>
        <p:spPr>
          <a:xfrm>
            <a:off x="814401" y="2863020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D08333-3F01-F417-A842-F543D5E9CCBA}"/>
              </a:ext>
            </a:extLst>
          </p:cNvPr>
          <p:cNvSpPr txBox="1"/>
          <p:nvPr/>
        </p:nvSpPr>
        <p:spPr>
          <a:xfrm>
            <a:off x="754575" y="4232114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2A7A2B-0968-EA33-E798-3558B1C7425D}"/>
              </a:ext>
            </a:extLst>
          </p:cNvPr>
          <p:cNvSpPr txBox="1"/>
          <p:nvPr/>
        </p:nvSpPr>
        <p:spPr>
          <a:xfrm>
            <a:off x="705328" y="469532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70DCCE-5191-F66E-0D36-601F4967362B}"/>
              </a:ext>
            </a:extLst>
          </p:cNvPr>
          <p:cNvSpPr txBox="1"/>
          <p:nvPr/>
        </p:nvSpPr>
        <p:spPr>
          <a:xfrm>
            <a:off x="859216" y="5172904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07DEAE-34E2-7AA5-78AC-43B7A8616CFD}"/>
              </a:ext>
            </a:extLst>
          </p:cNvPr>
          <p:cNvSpPr txBox="1"/>
          <p:nvPr/>
        </p:nvSpPr>
        <p:spPr>
          <a:xfrm>
            <a:off x="814401" y="5636174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95AABC-6776-4B87-BC23-9F4528B00B3B}"/>
              </a:ext>
            </a:extLst>
          </p:cNvPr>
          <p:cNvSpPr txBox="1"/>
          <p:nvPr/>
        </p:nvSpPr>
        <p:spPr>
          <a:xfrm>
            <a:off x="5832219" y="1458960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A81122-EEDD-E753-2FFF-C671F3CDA7EC}"/>
              </a:ext>
            </a:extLst>
          </p:cNvPr>
          <p:cNvSpPr txBox="1"/>
          <p:nvPr/>
        </p:nvSpPr>
        <p:spPr>
          <a:xfrm>
            <a:off x="5782972" y="192217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A7E09B1-A7ED-6023-0294-92B99E5F80CA}"/>
              </a:ext>
            </a:extLst>
          </p:cNvPr>
          <p:cNvSpPr txBox="1"/>
          <p:nvPr/>
        </p:nvSpPr>
        <p:spPr>
          <a:xfrm>
            <a:off x="5936860" y="2399750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77AD0EA-D882-57CA-8819-1AFEE740E94E}"/>
              </a:ext>
            </a:extLst>
          </p:cNvPr>
          <p:cNvSpPr txBox="1"/>
          <p:nvPr/>
        </p:nvSpPr>
        <p:spPr>
          <a:xfrm>
            <a:off x="5892045" y="2863020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058C287-8CB7-558A-7923-E66E63C4F59D}"/>
              </a:ext>
            </a:extLst>
          </p:cNvPr>
          <p:cNvSpPr txBox="1"/>
          <p:nvPr/>
        </p:nvSpPr>
        <p:spPr>
          <a:xfrm>
            <a:off x="5832150" y="4232114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4CA9A29-2849-4014-5F34-9EFD95FE1679}"/>
              </a:ext>
            </a:extLst>
          </p:cNvPr>
          <p:cNvSpPr txBox="1"/>
          <p:nvPr/>
        </p:nvSpPr>
        <p:spPr>
          <a:xfrm>
            <a:off x="5782903" y="469532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24(II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FF33432-24BC-3378-BC65-C0CC66C24809}"/>
              </a:ext>
            </a:extLst>
          </p:cNvPr>
          <p:cNvSpPr txBox="1"/>
          <p:nvPr/>
        </p:nvSpPr>
        <p:spPr>
          <a:xfrm>
            <a:off x="5936791" y="5172904"/>
            <a:ext cx="566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2845230-7649-9AF9-840C-AEE676F2453D}"/>
              </a:ext>
            </a:extLst>
          </p:cNvPr>
          <p:cNvSpPr txBox="1"/>
          <p:nvPr/>
        </p:nvSpPr>
        <p:spPr>
          <a:xfrm>
            <a:off x="5891976" y="5636174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24(II)</a:t>
            </a:r>
          </a:p>
        </p:txBody>
      </p:sp>
    </p:spTree>
    <p:extLst>
      <p:ext uri="{BB962C8B-B14F-4D97-AF65-F5344CB8AC3E}">
        <p14:creationId xmlns:p14="http://schemas.microsoft.com/office/powerpoint/2010/main" val="13061395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9A9A4964-605B-F92C-CDA7-787882E185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1276847"/>
              </p:ext>
            </p:extLst>
          </p:nvPr>
        </p:nvGraphicFramePr>
        <p:xfrm>
          <a:off x="4035185" y="4132780"/>
          <a:ext cx="3498565" cy="1722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46450">
                  <a:extLst>
                    <a:ext uri="{9D8B030D-6E8A-4147-A177-3AD203B41FA5}">
                      <a16:colId xmlns:a16="http://schemas.microsoft.com/office/drawing/2014/main" val="2116877151"/>
                    </a:ext>
                  </a:extLst>
                </a:gridCol>
                <a:gridCol w="1152115">
                  <a:extLst>
                    <a:ext uri="{9D8B030D-6E8A-4147-A177-3AD203B41FA5}">
                      <a16:colId xmlns:a16="http://schemas.microsoft.com/office/drawing/2014/main" val="402905134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Top 5 overrepresented </a:t>
                      </a:r>
                    </a:p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misc. RNY-mapped reads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+mn-lt"/>
                        </a:rPr>
                        <a:t>(SARS-CoV-2 infected Calu-3 cells)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dirty="0">
                          <a:solidFill>
                            <a:schemeClr val="tx1"/>
                          </a:solidFill>
                          <a:latin typeface="+mn-lt"/>
                        </a:rPr>
                        <a:t>% in: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7</a:t>
                      </a:r>
                    </a:p>
                    <a:p>
                      <a:pPr algn="ctr" fontAlgn="b"/>
                      <a:r>
                        <a:rPr lang="en-US" sz="1000" b="1" i="0" dirty="0">
                          <a:solidFill>
                            <a:schemeClr val="accent2">
                              <a:lumMod val="50000"/>
                            </a:schemeClr>
                          </a:solidFill>
                          <a:latin typeface="+mn-lt"/>
                        </a:rPr>
                        <a:t>SRR115500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8641959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CCCACTGCTTCACTTGACTAGCCC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.89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.64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57415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CCCACTGCTTCACTTGACTAGCC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.38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97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7906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CCCACTGCTTCACTTGACTAGCC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59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04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4811998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TCTCACTACTGCACTTGACTAGC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25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55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5540895"/>
                  </a:ext>
                </a:extLst>
              </a:tr>
              <a:tr h="2063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CCCACTGCTTCACTTGACTAGCC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94%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10%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4263235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339CC2F0-B8C4-BD6E-F67D-1CF811417790}"/>
              </a:ext>
            </a:extLst>
          </p:cNvPr>
          <p:cNvSpPr txBox="1"/>
          <p:nvPr/>
        </p:nvSpPr>
        <p:spPr>
          <a:xfrm>
            <a:off x="5348289" y="3622727"/>
            <a:ext cx="8210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Read lengt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F36985-1E8E-80A8-DF61-D811C06CC0DA}"/>
              </a:ext>
            </a:extLst>
          </p:cNvPr>
          <p:cNvSpPr txBox="1"/>
          <p:nvPr/>
        </p:nvSpPr>
        <p:spPr>
          <a:xfrm rot="16200000">
            <a:off x="3110414" y="2391896"/>
            <a:ext cx="16033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%  of total misc. RNY read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A15B6C2-609C-8470-27C9-5870D664806E}"/>
              </a:ext>
            </a:extLst>
          </p:cNvPr>
          <p:cNvSpPr txBox="1"/>
          <p:nvPr/>
        </p:nvSpPr>
        <p:spPr>
          <a:xfrm>
            <a:off x="80683" y="9293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8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76F508D-EC90-4EF5-8163-83FBA4BCE0B5}"/>
              </a:ext>
            </a:extLst>
          </p:cNvPr>
          <p:cNvGraphicFramePr>
            <a:graphicFrameLocks/>
          </p:cNvGraphicFramePr>
          <p:nvPr/>
        </p:nvGraphicFramePr>
        <p:xfrm>
          <a:off x="4028145" y="1255662"/>
          <a:ext cx="3499200" cy="244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65369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1</Words>
  <Application>Microsoft Office PowerPoint</Application>
  <PresentationFormat>Widescreen</PresentationFormat>
  <Paragraphs>416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y Turchinovich</dc:creator>
  <cp:lastModifiedBy>Andrey Turchinovich</cp:lastModifiedBy>
  <cp:revision>606</cp:revision>
  <dcterms:created xsi:type="dcterms:W3CDTF">2021-04-26T09:31:36Z</dcterms:created>
  <dcterms:modified xsi:type="dcterms:W3CDTF">2024-01-21T14:47:50Z</dcterms:modified>
</cp:coreProperties>
</file>